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8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7ABC32"/>
    <a:srgbClr val="0000FF"/>
    <a:srgbClr val="006600"/>
    <a:srgbClr val="4646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3369" autoAdjust="0"/>
  </p:normalViewPr>
  <p:slideViewPr>
    <p:cSldViewPr>
      <p:cViewPr varScale="1">
        <p:scale>
          <a:sx n="82" d="100"/>
          <a:sy n="82" d="100"/>
        </p:scale>
        <p:origin x="509" y="67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63B3A50-EC67-437A-8F25-AA2DEEF9C7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4A93E3-E057-4393-9459-3733C2E2FE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86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74597CD1-D7EA-4E4C-8545-23D334D93A35}" type="datetimeFigureOut">
              <a:rPr kumimoji="1" lang="ja-JP" altLang="en-US" smtClean="0"/>
              <a:t>2021/8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EFBBB-A0FD-47F0-A06C-361FD4C4E81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6AA335-5BC6-4274-8ED3-F3E1C9AF4BC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86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D5E56BB5-D718-4ED0-8D34-4ACEBFED3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581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r">
              <a:defRPr sz="1200"/>
            </a:lvl1pPr>
          </a:lstStyle>
          <a:p>
            <a:fld id="{75299133-6C75-4558-9524-1683EB80439F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2" tIns="46582" rIns="93162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3162" tIns="46582" rIns="93162" bIns="4658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r">
              <a:defRPr sz="1200"/>
            </a:lvl1pPr>
          </a:lstStyle>
          <a:p>
            <a:fld id="{621572A8-9031-41C0-808B-67CB58E6C5E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2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88900" y="744538"/>
            <a:ext cx="6619875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8719773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4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7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7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9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6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6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3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3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6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9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6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6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21B25-79C8-4BE8-B89E-C8E6BF116A78}" type="datetimeFigureOut">
              <a:rPr lang="en-US" smtClean="0"/>
              <a:pPr/>
              <a:t>8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9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D6038E-5028-4957-A6D1-E00876FF0080}"/>
              </a:ext>
            </a:extLst>
          </p:cNvPr>
          <p:cNvSpPr txBox="1"/>
          <p:nvPr/>
        </p:nvSpPr>
        <p:spPr>
          <a:xfrm>
            <a:off x="268468" y="87868"/>
            <a:ext cx="3559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D833DD19-C27C-4826-BCD6-74A71046600A}"/>
              </a:ext>
            </a:extLst>
          </p:cNvPr>
          <p:cNvSpPr txBox="1"/>
          <p:nvPr/>
        </p:nvSpPr>
        <p:spPr>
          <a:xfrm>
            <a:off x="192268" y="594891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7F1C3C13-75DC-4E4F-B506-AE9C933F16AA}"/>
              </a:ext>
            </a:extLst>
          </p:cNvPr>
          <p:cNvSpPr txBox="1"/>
          <p:nvPr/>
        </p:nvSpPr>
        <p:spPr>
          <a:xfrm>
            <a:off x="4162863" y="594891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2EE8EAF3-92C8-4D6C-B281-08478EC814BE}"/>
              </a:ext>
            </a:extLst>
          </p:cNvPr>
          <p:cNvSpPr txBox="1"/>
          <p:nvPr/>
        </p:nvSpPr>
        <p:spPr>
          <a:xfrm>
            <a:off x="8133458" y="594891"/>
            <a:ext cx="27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3" name="グループ化 222">
            <a:extLst>
              <a:ext uri="{FF2B5EF4-FFF2-40B4-BE49-F238E27FC236}">
                <a16:creationId xmlns:a16="http://schemas.microsoft.com/office/drawing/2014/main" id="{29D4CC81-FF23-47BB-876D-807C1CE48905}"/>
              </a:ext>
            </a:extLst>
          </p:cNvPr>
          <p:cNvGrpSpPr/>
          <p:nvPr/>
        </p:nvGrpSpPr>
        <p:grpSpPr>
          <a:xfrm>
            <a:off x="749847" y="1071136"/>
            <a:ext cx="3137768" cy="2222044"/>
            <a:chOff x="733425" y="1970088"/>
            <a:chExt cx="3137768" cy="2222044"/>
          </a:xfrm>
        </p:grpSpPr>
        <p:sp>
          <p:nvSpPr>
            <p:cNvPr id="6" name="Line 6">
              <a:extLst>
                <a:ext uri="{FF2B5EF4-FFF2-40B4-BE49-F238E27FC236}">
                  <a16:creationId xmlns:a16="http://schemas.microsoft.com/office/drawing/2014/main" id="{5F7397C0-F8AA-42D7-87B9-0F26C65910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39052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7A41EFF1-EAF5-498D-BBFE-0FB46946A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38131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8">
              <a:extLst>
                <a:ext uri="{FF2B5EF4-FFF2-40B4-BE49-F238E27FC236}">
                  <a16:creationId xmlns:a16="http://schemas.microsoft.com/office/drawing/2014/main" id="{808280CA-C9BF-4F6A-805D-9D821CBDFD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8375" y="37211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9">
              <a:extLst>
                <a:ext uri="{FF2B5EF4-FFF2-40B4-BE49-F238E27FC236}">
                  <a16:creationId xmlns:a16="http://schemas.microsoft.com/office/drawing/2014/main" id="{90F9B80A-351B-4E4E-89B7-3D9BE3165E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35369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Rectangle 10">
              <a:extLst>
                <a:ext uri="{FF2B5EF4-FFF2-40B4-BE49-F238E27FC236}">
                  <a16:creationId xmlns:a16="http://schemas.microsoft.com/office/drawing/2014/main" id="{0EADE855-FE5E-4227-9F03-FA3790A2E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34448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Line 11">
              <a:extLst>
                <a:ext uri="{FF2B5EF4-FFF2-40B4-BE49-F238E27FC236}">
                  <a16:creationId xmlns:a16="http://schemas.microsoft.com/office/drawing/2014/main" id="{AA4391DD-5104-43EB-9CBD-7EF4A431DA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8375" y="33528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Line 12">
              <a:extLst>
                <a:ext uri="{FF2B5EF4-FFF2-40B4-BE49-F238E27FC236}">
                  <a16:creationId xmlns:a16="http://schemas.microsoft.com/office/drawing/2014/main" id="{AFBD7A37-7BCF-4408-8606-3AD756186C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31686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Rectangle 13">
              <a:extLst>
                <a:ext uri="{FF2B5EF4-FFF2-40B4-BE49-F238E27FC236}">
                  <a16:creationId xmlns:a16="http://schemas.microsoft.com/office/drawing/2014/main" id="{DAFE9A94-5517-42FA-9984-68DE1DD0F3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30765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Line 14">
              <a:extLst>
                <a:ext uri="{FF2B5EF4-FFF2-40B4-BE49-F238E27FC236}">
                  <a16:creationId xmlns:a16="http://schemas.microsoft.com/office/drawing/2014/main" id="{FECDB1D2-D383-4E4C-BF1D-BB46EEAF48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8375" y="29845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Line 15">
              <a:extLst>
                <a:ext uri="{FF2B5EF4-FFF2-40B4-BE49-F238E27FC236}">
                  <a16:creationId xmlns:a16="http://schemas.microsoft.com/office/drawing/2014/main" id="{CDA31D48-406A-4480-80AE-9F224F137B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28003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Rectangle 16">
              <a:extLst>
                <a:ext uri="{FF2B5EF4-FFF2-40B4-BE49-F238E27FC236}">
                  <a16:creationId xmlns:a16="http://schemas.microsoft.com/office/drawing/2014/main" id="{46C4AF8B-6AC5-40DA-8A11-7D4F10E52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27082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Line 17">
              <a:extLst>
                <a:ext uri="{FF2B5EF4-FFF2-40B4-BE49-F238E27FC236}">
                  <a16:creationId xmlns:a16="http://schemas.microsoft.com/office/drawing/2014/main" id="{89FD8D17-7B28-4910-8DC4-92DFB4C1B5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8375" y="26162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Line 18">
              <a:extLst>
                <a:ext uri="{FF2B5EF4-FFF2-40B4-BE49-F238E27FC236}">
                  <a16:creationId xmlns:a16="http://schemas.microsoft.com/office/drawing/2014/main" id="{BA751DFA-9C26-40B0-864F-9D56C56AA9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24320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Rectangle 19">
              <a:extLst>
                <a:ext uri="{FF2B5EF4-FFF2-40B4-BE49-F238E27FC236}">
                  <a16:creationId xmlns:a16="http://schemas.microsoft.com/office/drawing/2014/main" id="{E596336C-F429-4B24-89C6-0AC9BFE314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23399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Line 20">
              <a:extLst>
                <a:ext uri="{FF2B5EF4-FFF2-40B4-BE49-F238E27FC236}">
                  <a16:creationId xmlns:a16="http://schemas.microsoft.com/office/drawing/2014/main" id="{53AEB8F9-47D4-4031-A337-19C23A759E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68375" y="22479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Line 21">
              <a:extLst>
                <a:ext uri="{FF2B5EF4-FFF2-40B4-BE49-F238E27FC236}">
                  <a16:creationId xmlns:a16="http://schemas.microsoft.com/office/drawing/2014/main" id="{0DAEE025-A3FB-427E-A5BF-1348A3CDD0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6625" y="20637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22">
              <a:extLst>
                <a:ext uri="{FF2B5EF4-FFF2-40B4-BE49-F238E27FC236}">
                  <a16:creationId xmlns:a16="http://schemas.microsoft.com/office/drawing/2014/main" id="{00AF9D33-CE93-407B-BE87-989EE5490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5" y="197008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Freeform 27">
              <a:extLst>
                <a:ext uri="{FF2B5EF4-FFF2-40B4-BE49-F238E27FC236}">
                  <a16:creationId xmlns:a16="http://schemas.microsoft.com/office/drawing/2014/main" id="{DF0D19B9-F9F0-4903-BC63-443164136E68}"/>
                </a:ext>
              </a:extLst>
            </p:cNvPr>
            <p:cNvSpPr>
              <a:spLocks/>
            </p:cNvSpPr>
            <p:nvPr/>
          </p:nvSpPr>
          <p:spPr bwMode="auto">
            <a:xfrm>
              <a:off x="998538" y="2063751"/>
              <a:ext cx="2822575" cy="685800"/>
            </a:xfrm>
            <a:custGeom>
              <a:avLst/>
              <a:gdLst>
                <a:gd name="T0" fmla="*/ 0 w 1778"/>
                <a:gd name="T1" fmla="*/ 0 h 432"/>
                <a:gd name="T2" fmla="*/ 142 w 1778"/>
                <a:gd name="T3" fmla="*/ 0 h 432"/>
                <a:gd name="T4" fmla="*/ 142 w 1778"/>
                <a:gd name="T5" fmla="*/ 19 h 432"/>
                <a:gd name="T6" fmla="*/ 226 w 1778"/>
                <a:gd name="T7" fmla="*/ 19 h 432"/>
                <a:gd name="T8" fmla="*/ 238 w 1778"/>
                <a:gd name="T9" fmla="*/ 19 h 432"/>
                <a:gd name="T10" fmla="*/ 303 w 1778"/>
                <a:gd name="T11" fmla="*/ 19 h 432"/>
                <a:gd name="T12" fmla="*/ 303 w 1778"/>
                <a:gd name="T13" fmla="*/ 38 h 432"/>
                <a:gd name="T14" fmla="*/ 354 w 1778"/>
                <a:gd name="T15" fmla="*/ 38 h 432"/>
                <a:gd name="T16" fmla="*/ 393 w 1778"/>
                <a:gd name="T17" fmla="*/ 38 h 432"/>
                <a:gd name="T18" fmla="*/ 393 w 1778"/>
                <a:gd name="T19" fmla="*/ 58 h 432"/>
                <a:gd name="T20" fmla="*/ 425 w 1778"/>
                <a:gd name="T21" fmla="*/ 58 h 432"/>
                <a:gd name="T22" fmla="*/ 490 w 1778"/>
                <a:gd name="T23" fmla="*/ 58 h 432"/>
                <a:gd name="T24" fmla="*/ 496 w 1778"/>
                <a:gd name="T25" fmla="*/ 58 h 432"/>
                <a:gd name="T26" fmla="*/ 496 w 1778"/>
                <a:gd name="T27" fmla="*/ 77 h 432"/>
                <a:gd name="T28" fmla="*/ 573 w 1778"/>
                <a:gd name="T29" fmla="*/ 77 h 432"/>
                <a:gd name="T30" fmla="*/ 573 w 1778"/>
                <a:gd name="T31" fmla="*/ 103 h 432"/>
                <a:gd name="T32" fmla="*/ 580 w 1778"/>
                <a:gd name="T33" fmla="*/ 103 h 432"/>
                <a:gd name="T34" fmla="*/ 580 w 1778"/>
                <a:gd name="T35" fmla="*/ 122 h 432"/>
                <a:gd name="T36" fmla="*/ 657 w 1778"/>
                <a:gd name="T37" fmla="*/ 122 h 432"/>
                <a:gd name="T38" fmla="*/ 702 w 1778"/>
                <a:gd name="T39" fmla="*/ 122 h 432"/>
                <a:gd name="T40" fmla="*/ 702 w 1778"/>
                <a:gd name="T41" fmla="*/ 141 h 432"/>
                <a:gd name="T42" fmla="*/ 728 w 1778"/>
                <a:gd name="T43" fmla="*/ 141 h 432"/>
                <a:gd name="T44" fmla="*/ 728 w 1778"/>
                <a:gd name="T45" fmla="*/ 161 h 432"/>
                <a:gd name="T46" fmla="*/ 735 w 1778"/>
                <a:gd name="T47" fmla="*/ 161 h 432"/>
                <a:gd name="T48" fmla="*/ 735 w 1778"/>
                <a:gd name="T49" fmla="*/ 187 h 432"/>
                <a:gd name="T50" fmla="*/ 760 w 1778"/>
                <a:gd name="T51" fmla="*/ 187 h 432"/>
                <a:gd name="T52" fmla="*/ 760 w 1778"/>
                <a:gd name="T53" fmla="*/ 206 h 432"/>
                <a:gd name="T54" fmla="*/ 760 w 1778"/>
                <a:gd name="T55" fmla="*/ 225 h 432"/>
                <a:gd name="T56" fmla="*/ 780 w 1778"/>
                <a:gd name="T57" fmla="*/ 225 h 432"/>
                <a:gd name="T58" fmla="*/ 780 w 1778"/>
                <a:gd name="T59" fmla="*/ 251 h 432"/>
                <a:gd name="T60" fmla="*/ 909 w 1778"/>
                <a:gd name="T61" fmla="*/ 251 h 432"/>
                <a:gd name="T62" fmla="*/ 986 w 1778"/>
                <a:gd name="T63" fmla="*/ 251 h 432"/>
                <a:gd name="T64" fmla="*/ 992 w 1778"/>
                <a:gd name="T65" fmla="*/ 251 h 432"/>
                <a:gd name="T66" fmla="*/ 992 w 1778"/>
                <a:gd name="T67" fmla="*/ 270 h 432"/>
                <a:gd name="T68" fmla="*/ 1018 w 1778"/>
                <a:gd name="T69" fmla="*/ 270 h 432"/>
                <a:gd name="T70" fmla="*/ 1057 w 1778"/>
                <a:gd name="T71" fmla="*/ 270 h 432"/>
                <a:gd name="T72" fmla="*/ 1057 w 1778"/>
                <a:gd name="T73" fmla="*/ 296 h 432"/>
                <a:gd name="T74" fmla="*/ 1082 w 1778"/>
                <a:gd name="T75" fmla="*/ 296 h 432"/>
                <a:gd name="T76" fmla="*/ 1108 w 1778"/>
                <a:gd name="T77" fmla="*/ 296 h 432"/>
                <a:gd name="T78" fmla="*/ 1192 w 1778"/>
                <a:gd name="T79" fmla="*/ 296 h 432"/>
                <a:gd name="T80" fmla="*/ 1302 w 1778"/>
                <a:gd name="T81" fmla="*/ 296 h 432"/>
                <a:gd name="T82" fmla="*/ 1302 w 1778"/>
                <a:gd name="T83" fmla="*/ 296 h 432"/>
                <a:gd name="T84" fmla="*/ 1327 w 1778"/>
                <a:gd name="T85" fmla="*/ 296 h 432"/>
                <a:gd name="T86" fmla="*/ 1327 w 1778"/>
                <a:gd name="T87" fmla="*/ 322 h 432"/>
                <a:gd name="T88" fmla="*/ 1340 w 1778"/>
                <a:gd name="T89" fmla="*/ 322 h 432"/>
                <a:gd name="T90" fmla="*/ 1340 w 1778"/>
                <a:gd name="T91" fmla="*/ 348 h 432"/>
                <a:gd name="T92" fmla="*/ 1398 w 1778"/>
                <a:gd name="T93" fmla="*/ 348 h 432"/>
                <a:gd name="T94" fmla="*/ 1443 w 1778"/>
                <a:gd name="T95" fmla="*/ 348 h 432"/>
                <a:gd name="T96" fmla="*/ 1443 w 1778"/>
                <a:gd name="T97" fmla="*/ 374 h 432"/>
                <a:gd name="T98" fmla="*/ 1443 w 1778"/>
                <a:gd name="T99" fmla="*/ 399 h 432"/>
                <a:gd name="T100" fmla="*/ 1514 w 1778"/>
                <a:gd name="T101" fmla="*/ 399 h 432"/>
                <a:gd name="T102" fmla="*/ 1592 w 1778"/>
                <a:gd name="T103" fmla="*/ 399 h 432"/>
                <a:gd name="T104" fmla="*/ 1669 w 1778"/>
                <a:gd name="T105" fmla="*/ 399 h 432"/>
                <a:gd name="T106" fmla="*/ 1669 w 1778"/>
                <a:gd name="T107" fmla="*/ 432 h 432"/>
                <a:gd name="T108" fmla="*/ 1733 w 1778"/>
                <a:gd name="T109" fmla="*/ 432 h 432"/>
                <a:gd name="T110" fmla="*/ 1778 w 1778"/>
                <a:gd name="T111" fmla="*/ 432 h 4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778" h="432">
                  <a:moveTo>
                    <a:pt x="0" y="0"/>
                  </a:moveTo>
                  <a:lnTo>
                    <a:pt x="142" y="0"/>
                  </a:lnTo>
                  <a:lnTo>
                    <a:pt x="142" y="19"/>
                  </a:lnTo>
                  <a:lnTo>
                    <a:pt x="226" y="19"/>
                  </a:lnTo>
                  <a:lnTo>
                    <a:pt x="238" y="19"/>
                  </a:lnTo>
                  <a:lnTo>
                    <a:pt x="303" y="19"/>
                  </a:lnTo>
                  <a:lnTo>
                    <a:pt x="303" y="38"/>
                  </a:lnTo>
                  <a:lnTo>
                    <a:pt x="354" y="38"/>
                  </a:lnTo>
                  <a:lnTo>
                    <a:pt x="393" y="38"/>
                  </a:lnTo>
                  <a:lnTo>
                    <a:pt x="393" y="58"/>
                  </a:lnTo>
                  <a:lnTo>
                    <a:pt x="425" y="58"/>
                  </a:lnTo>
                  <a:lnTo>
                    <a:pt x="490" y="58"/>
                  </a:lnTo>
                  <a:lnTo>
                    <a:pt x="496" y="58"/>
                  </a:lnTo>
                  <a:lnTo>
                    <a:pt x="496" y="77"/>
                  </a:lnTo>
                  <a:lnTo>
                    <a:pt x="573" y="77"/>
                  </a:lnTo>
                  <a:lnTo>
                    <a:pt x="573" y="103"/>
                  </a:lnTo>
                  <a:lnTo>
                    <a:pt x="580" y="103"/>
                  </a:lnTo>
                  <a:lnTo>
                    <a:pt x="580" y="122"/>
                  </a:lnTo>
                  <a:lnTo>
                    <a:pt x="657" y="122"/>
                  </a:lnTo>
                  <a:lnTo>
                    <a:pt x="702" y="122"/>
                  </a:lnTo>
                  <a:lnTo>
                    <a:pt x="702" y="141"/>
                  </a:lnTo>
                  <a:lnTo>
                    <a:pt x="728" y="141"/>
                  </a:lnTo>
                  <a:lnTo>
                    <a:pt x="728" y="161"/>
                  </a:lnTo>
                  <a:lnTo>
                    <a:pt x="735" y="161"/>
                  </a:lnTo>
                  <a:lnTo>
                    <a:pt x="735" y="187"/>
                  </a:lnTo>
                  <a:lnTo>
                    <a:pt x="760" y="187"/>
                  </a:lnTo>
                  <a:lnTo>
                    <a:pt x="760" y="206"/>
                  </a:lnTo>
                  <a:lnTo>
                    <a:pt x="760" y="225"/>
                  </a:lnTo>
                  <a:lnTo>
                    <a:pt x="780" y="225"/>
                  </a:lnTo>
                  <a:lnTo>
                    <a:pt x="780" y="251"/>
                  </a:lnTo>
                  <a:lnTo>
                    <a:pt x="909" y="251"/>
                  </a:lnTo>
                  <a:lnTo>
                    <a:pt x="986" y="251"/>
                  </a:lnTo>
                  <a:lnTo>
                    <a:pt x="992" y="251"/>
                  </a:lnTo>
                  <a:lnTo>
                    <a:pt x="992" y="270"/>
                  </a:lnTo>
                  <a:lnTo>
                    <a:pt x="1018" y="270"/>
                  </a:lnTo>
                  <a:lnTo>
                    <a:pt x="1057" y="270"/>
                  </a:lnTo>
                  <a:lnTo>
                    <a:pt x="1057" y="296"/>
                  </a:lnTo>
                  <a:lnTo>
                    <a:pt x="1082" y="296"/>
                  </a:lnTo>
                  <a:lnTo>
                    <a:pt x="1108" y="296"/>
                  </a:lnTo>
                  <a:lnTo>
                    <a:pt x="1192" y="296"/>
                  </a:lnTo>
                  <a:lnTo>
                    <a:pt x="1302" y="296"/>
                  </a:lnTo>
                  <a:lnTo>
                    <a:pt x="1302" y="296"/>
                  </a:lnTo>
                  <a:lnTo>
                    <a:pt x="1327" y="296"/>
                  </a:lnTo>
                  <a:lnTo>
                    <a:pt x="1327" y="322"/>
                  </a:lnTo>
                  <a:lnTo>
                    <a:pt x="1340" y="322"/>
                  </a:lnTo>
                  <a:lnTo>
                    <a:pt x="1340" y="348"/>
                  </a:lnTo>
                  <a:lnTo>
                    <a:pt x="1398" y="348"/>
                  </a:lnTo>
                  <a:lnTo>
                    <a:pt x="1443" y="348"/>
                  </a:lnTo>
                  <a:lnTo>
                    <a:pt x="1443" y="374"/>
                  </a:lnTo>
                  <a:lnTo>
                    <a:pt x="1443" y="399"/>
                  </a:lnTo>
                  <a:lnTo>
                    <a:pt x="1514" y="399"/>
                  </a:lnTo>
                  <a:lnTo>
                    <a:pt x="1592" y="399"/>
                  </a:lnTo>
                  <a:lnTo>
                    <a:pt x="1669" y="399"/>
                  </a:lnTo>
                  <a:lnTo>
                    <a:pt x="1669" y="432"/>
                  </a:lnTo>
                  <a:lnTo>
                    <a:pt x="1733" y="432"/>
                  </a:lnTo>
                  <a:lnTo>
                    <a:pt x="1778" y="432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Freeform 28">
              <a:extLst>
                <a:ext uri="{FF2B5EF4-FFF2-40B4-BE49-F238E27FC236}">
                  <a16:creationId xmlns:a16="http://schemas.microsoft.com/office/drawing/2014/main" id="{B5385E03-DB46-4924-953A-F9000A52D8C7}"/>
                </a:ext>
              </a:extLst>
            </p:cNvPr>
            <p:cNvSpPr>
              <a:spLocks/>
            </p:cNvSpPr>
            <p:nvPr/>
          </p:nvSpPr>
          <p:spPr bwMode="auto">
            <a:xfrm>
              <a:off x="998538" y="2063751"/>
              <a:ext cx="2822575" cy="930275"/>
            </a:xfrm>
            <a:custGeom>
              <a:avLst/>
              <a:gdLst>
                <a:gd name="T0" fmla="*/ 103 w 1778"/>
                <a:gd name="T1" fmla="*/ 0 h 586"/>
                <a:gd name="T2" fmla="*/ 122 w 1778"/>
                <a:gd name="T3" fmla="*/ 19 h 586"/>
                <a:gd name="T4" fmla="*/ 264 w 1778"/>
                <a:gd name="T5" fmla="*/ 19 h 586"/>
                <a:gd name="T6" fmla="*/ 309 w 1778"/>
                <a:gd name="T7" fmla="*/ 38 h 586"/>
                <a:gd name="T8" fmla="*/ 348 w 1778"/>
                <a:gd name="T9" fmla="*/ 58 h 586"/>
                <a:gd name="T10" fmla="*/ 374 w 1778"/>
                <a:gd name="T11" fmla="*/ 77 h 586"/>
                <a:gd name="T12" fmla="*/ 425 w 1778"/>
                <a:gd name="T13" fmla="*/ 116 h 586"/>
                <a:gd name="T14" fmla="*/ 445 w 1778"/>
                <a:gd name="T15" fmla="*/ 135 h 586"/>
                <a:gd name="T16" fmla="*/ 638 w 1778"/>
                <a:gd name="T17" fmla="*/ 135 h 586"/>
                <a:gd name="T18" fmla="*/ 670 w 1778"/>
                <a:gd name="T19" fmla="*/ 154 h 586"/>
                <a:gd name="T20" fmla="*/ 696 w 1778"/>
                <a:gd name="T21" fmla="*/ 174 h 586"/>
                <a:gd name="T22" fmla="*/ 709 w 1778"/>
                <a:gd name="T23" fmla="*/ 193 h 586"/>
                <a:gd name="T24" fmla="*/ 722 w 1778"/>
                <a:gd name="T25" fmla="*/ 212 h 586"/>
                <a:gd name="T26" fmla="*/ 773 w 1778"/>
                <a:gd name="T27" fmla="*/ 232 h 586"/>
                <a:gd name="T28" fmla="*/ 786 w 1778"/>
                <a:gd name="T29" fmla="*/ 258 h 586"/>
                <a:gd name="T30" fmla="*/ 870 w 1778"/>
                <a:gd name="T31" fmla="*/ 277 h 586"/>
                <a:gd name="T32" fmla="*/ 915 w 1778"/>
                <a:gd name="T33" fmla="*/ 296 h 586"/>
                <a:gd name="T34" fmla="*/ 992 w 1778"/>
                <a:gd name="T35" fmla="*/ 296 h 586"/>
                <a:gd name="T36" fmla="*/ 999 w 1778"/>
                <a:gd name="T37" fmla="*/ 322 h 586"/>
                <a:gd name="T38" fmla="*/ 1037 w 1778"/>
                <a:gd name="T39" fmla="*/ 322 h 586"/>
                <a:gd name="T40" fmla="*/ 1050 w 1778"/>
                <a:gd name="T41" fmla="*/ 341 h 586"/>
                <a:gd name="T42" fmla="*/ 1089 w 1778"/>
                <a:gd name="T43" fmla="*/ 341 h 586"/>
                <a:gd name="T44" fmla="*/ 1102 w 1778"/>
                <a:gd name="T45" fmla="*/ 367 h 586"/>
                <a:gd name="T46" fmla="*/ 1140 w 1778"/>
                <a:gd name="T47" fmla="*/ 367 h 586"/>
                <a:gd name="T48" fmla="*/ 1166 w 1778"/>
                <a:gd name="T49" fmla="*/ 393 h 586"/>
                <a:gd name="T50" fmla="*/ 1231 w 1778"/>
                <a:gd name="T51" fmla="*/ 393 h 586"/>
                <a:gd name="T52" fmla="*/ 1282 w 1778"/>
                <a:gd name="T53" fmla="*/ 393 h 586"/>
                <a:gd name="T54" fmla="*/ 1385 w 1778"/>
                <a:gd name="T55" fmla="*/ 425 h 586"/>
                <a:gd name="T56" fmla="*/ 1437 w 1778"/>
                <a:gd name="T57" fmla="*/ 457 h 586"/>
                <a:gd name="T58" fmla="*/ 1456 w 1778"/>
                <a:gd name="T59" fmla="*/ 490 h 586"/>
                <a:gd name="T60" fmla="*/ 1527 w 1778"/>
                <a:gd name="T61" fmla="*/ 522 h 586"/>
                <a:gd name="T62" fmla="*/ 1585 w 1778"/>
                <a:gd name="T63" fmla="*/ 554 h 586"/>
                <a:gd name="T64" fmla="*/ 1611 w 1778"/>
                <a:gd name="T65" fmla="*/ 586 h 5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778" h="586">
                  <a:moveTo>
                    <a:pt x="0" y="0"/>
                  </a:moveTo>
                  <a:lnTo>
                    <a:pt x="103" y="0"/>
                  </a:lnTo>
                  <a:lnTo>
                    <a:pt x="122" y="0"/>
                  </a:lnTo>
                  <a:lnTo>
                    <a:pt x="122" y="19"/>
                  </a:lnTo>
                  <a:lnTo>
                    <a:pt x="180" y="19"/>
                  </a:lnTo>
                  <a:lnTo>
                    <a:pt x="264" y="19"/>
                  </a:lnTo>
                  <a:lnTo>
                    <a:pt x="264" y="38"/>
                  </a:lnTo>
                  <a:lnTo>
                    <a:pt x="309" y="38"/>
                  </a:lnTo>
                  <a:lnTo>
                    <a:pt x="309" y="58"/>
                  </a:lnTo>
                  <a:lnTo>
                    <a:pt x="348" y="58"/>
                  </a:lnTo>
                  <a:lnTo>
                    <a:pt x="348" y="77"/>
                  </a:lnTo>
                  <a:lnTo>
                    <a:pt x="374" y="77"/>
                  </a:lnTo>
                  <a:lnTo>
                    <a:pt x="374" y="116"/>
                  </a:lnTo>
                  <a:lnTo>
                    <a:pt x="425" y="116"/>
                  </a:lnTo>
                  <a:lnTo>
                    <a:pt x="445" y="116"/>
                  </a:lnTo>
                  <a:lnTo>
                    <a:pt x="445" y="135"/>
                  </a:lnTo>
                  <a:lnTo>
                    <a:pt x="573" y="135"/>
                  </a:lnTo>
                  <a:lnTo>
                    <a:pt x="638" y="135"/>
                  </a:lnTo>
                  <a:lnTo>
                    <a:pt x="670" y="135"/>
                  </a:lnTo>
                  <a:lnTo>
                    <a:pt x="670" y="154"/>
                  </a:lnTo>
                  <a:lnTo>
                    <a:pt x="696" y="154"/>
                  </a:lnTo>
                  <a:lnTo>
                    <a:pt x="696" y="174"/>
                  </a:lnTo>
                  <a:lnTo>
                    <a:pt x="709" y="174"/>
                  </a:lnTo>
                  <a:lnTo>
                    <a:pt x="709" y="193"/>
                  </a:lnTo>
                  <a:lnTo>
                    <a:pt x="722" y="193"/>
                  </a:lnTo>
                  <a:lnTo>
                    <a:pt x="722" y="212"/>
                  </a:lnTo>
                  <a:lnTo>
                    <a:pt x="773" y="212"/>
                  </a:lnTo>
                  <a:lnTo>
                    <a:pt x="773" y="232"/>
                  </a:lnTo>
                  <a:lnTo>
                    <a:pt x="786" y="232"/>
                  </a:lnTo>
                  <a:lnTo>
                    <a:pt x="786" y="258"/>
                  </a:lnTo>
                  <a:lnTo>
                    <a:pt x="870" y="258"/>
                  </a:lnTo>
                  <a:lnTo>
                    <a:pt x="870" y="277"/>
                  </a:lnTo>
                  <a:lnTo>
                    <a:pt x="915" y="277"/>
                  </a:lnTo>
                  <a:lnTo>
                    <a:pt x="915" y="296"/>
                  </a:lnTo>
                  <a:lnTo>
                    <a:pt x="967" y="296"/>
                  </a:lnTo>
                  <a:lnTo>
                    <a:pt x="992" y="296"/>
                  </a:lnTo>
                  <a:lnTo>
                    <a:pt x="992" y="322"/>
                  </a:lnTo>
                  <a:lnTo>
                    <a:pt x="999" y="322"/>
                  </a:lnTo>
                  <a:lnTo>
                    <a:pt x="1012" y="322"/>
                  </a:lnTo>
                  <a:lnTo>
                    <a:pt x="1037" y="322"/>
                  </a:lnTo>
                  <a:lnTo>
                    <a:pt x="1050" y="322"/>
                  </a:lnTo>
                  <a:lnTo>
                    <a:pt x="1050" y="341"/>
                  </a:lnTo>
                  <a:lnTo>
                    <a:pt x="1089" y="341"/>
                  </a:lnTo>
                  <a:lnTo>
                    <a:pt x="1089" y="341"/>
                  </a:lnTo>
                  <a:lnTo>
                    <a:pt x="1089" y="367"/>
                  </a:lnTo>
                  <a:lnTo>
                    <a:pt x="1102" y="367"/>
                  </a:lnTo>
                  <a:lnTo>
                    <a:pt x="1115" y="367"/>
                  </a:lnTo>
                  <a:lnTo>
                    <a:pt x="1140" y="367"/>
                  </a:lnTo>
                  <a:lnTo>
                    <a:pt x="1166" y="367"/>
                  </a:lnTo>
                  <a:lnTo>
                    <a:pt x="1166" y="393"/>
                  </a:lnTo>
                  <a:lnTo>
                    <a:pt x="1186" y="393"/>
                  </a:lnTo>
                  <a:lnTo>
                    <a:pt x="1231" y="393"/>
                  </a:lnTo>
                  <a:lnTo>
                    <a:pt x="1256" y="393"/>
                  </a:lnTo>
                  <a:lnTo>
                    <a:pt x="1282" y="393"/>
                  </a:lnTo>
                  <a:lnTo>
                    <a:pt x="1282" y="425"/>
                  </a:lnTo>
                  <a:lnTo>
                    <a:pt x="1385" y="425"/>
                  </a:lnTo>
                  <a:lnTo>
                    <a:pt x="1385" y="457"/>
                  </a:lnTo>
                  <a:lnTo>
                    <a:pt x="1437" y="457"/>
                  </a:lnTo>
                  <a:lnTo>
                    <a:pt x="1456" y="457"/>
                  </a:lnTo>
                  <a:lnTo>
                    <a:pt x="1456" y="490"/>
                  </a:lnTo>
                  <a:lnTo>
                    <a:pt x="1527" y="490"/>
                  </a:lnTo>
                  <a:lnTo>
                    <a:pt x="1527" y="522"/>
                  </a:lnTo>
                  <a:lnTo>
                    <a:pt x="1585" y="522"/>
                  </a:lnTo>
                  <a:lnTo>
                    <a:pt x="1585" y="554"/>
                  </a:lnTo>
                  <a:lnTo>
                    <a:pt x="1611" y="554"/>
                  </a:lnTo>
                  <a:lnTo>
                    <a:pt x="1611" y="586"/>
                  </a:lnTo>
                  <a:lnTo>
                    <a:pt x="1778" y="586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Freeform 29">
              <a:extLst>
                <a:ext uri="{FF2B5EF4-FFF2-40B4-BE49-F238E27FC236}">
                  <a16:creationId xmlns:a16="http://schemas.microsoft.com/office/drawing/2014/main" id="{470F3E62-2A25-48C1-B0B0-11E0B1C1296B}"/>
                </a:ext>
              </a:extLst>
            </p:cNvPr>
            <p:cNvSpPr>
              <a:spLocks/>
            </p:cNvSpPr>
            <p:nvPr/>
          </p:nvSpPr>
          <p:spPr bwMode="auto">
            <a:xfrm>
              <a:off x="998538" y="2063751"/>
              <a:ext cx="2822575" cy="695325"/>
            </a:xfrm>
            <a:custGeom>
              <a:avLst/>
              <a:gdLst>
                <a:gd name="T0" fmla="*/ 0 w 1778"/>
                <a:gd name="T1" fmla="*/ 0 h 438"/>
                <a:gd name="T2" fmla="*/ 13 w 1778"/>
                <a:gd name="T3" fmla="*/ 0 h 438"/>
                <a:gd name="T4" fmla="*/ 13 w 1778"/>
                <a:gd name="T5" fmla="*/ 19 h 438"/>
                <a:gd name="T6" fmla="*/ 26 w 1778"/>
                <a:gd name="T7" fmla="*/ 19 h 438"/>
                <a:gd name="T8" fmla="*/ 45 w 1778"/>
                <a:gd name="T9" fmla="*/ 19 h 438"/>
                <a:gd name="T10" fmla="*/ 64 w 1778"/>
                <a:gd name="T11" fmla="*/ 19 h 438"/>
                <a:gd name="T12" fmla="*/ 64 w 1778"/>
                <a:gd name="T13" fmla="*/ 38 h 438"/>
                <a:gd name="T14" fmla="*/ 168 w 1778"/>
                <a:gd name="T15" fmla="*/ 38 h 438"/>
                <a:gd name="T16" fmla="*/ 168 w 1778"/>
                <a:gd name="T17" fmla="*/ 64 h 438"/>
                <a:gd name="T18" fmla="*/ 284 w 1778"/>
                <a:gd name="T19" fmla="*/ 64 h 438"/>
                <a:gd name="T20" fmla="*/ 329 w 1778"/>
                <a:gd name="T21" fmla="*/ 64 h 438"/>
                <a:gd name="T22" fmla="*/ 342 w 1778"/>
                <a:gd name="T23" fmla="*/ 64 h 438"/>
                <a:gd name="T24" fmla="*/ 342 w 1778"/>
                <a:gd name="T25" fmla="*/ 83 h 438"/>
                <a:gd name="T26" fmla="*/ 354 w 1778"/>
                <a:gd name="T27" fmla="*/ 83 h 438"/>
                <a:gd name="T28" fmla="*/ 361 w 1778"/>
                <a:gd name="T29" fmla="*/ 83 h 438"/>
                <a:gd name="T30" fmla="*/ 361 w 1778"/>
                <a:gd name="T31" fmla="*/ 109 h 438"/>
                <a:gd name="T32" fmla="*/ 393 w 1778"/>
                <a:gd name="T33" fmla="*/ 109 h 438"/>
                <a:gd name="T34" fmla="*/ 400 w 1778"/>
                <a:gd name="T35" fmla="*/ 109 h 438"/>
                <a:gd name="T36" fmla="*/ 400 w 1778"/>
                <a:gd name="T37" fmla="*/ 129 h 438"/>
                <a:gd name="T38" fmla="*/ 406 w 1778"/>
                <a:gd name="T39" fmla="*/ 129 h 438"/>
                <a:gd name="T40" fmla="*/ 406 w 1778"/>
                <a:gd name="T41" fmla="*/ 154 h 438"/>
                <a:gd name="T42" fmla="*/ 432 w 1778"/>
                <a:gd name="T43" fmla="*/ 154 h 438"/>
                <a:gd name="T44" fmla="*/ 438 w 1778"/>
                <a:gd name="T45" fmla="*/ 154 h 438"/>
                <a:gd name="T46" fmla="*/ 554 w 1778"/>
                <a:gd name="T47" fmla="*/ 154 h 438"/>
                <a:gd name="T48" fmla="*/ 573 w 1778"/>
                <a:gd name="T49" fmla="*/ 154 h 438"/>
                <a:gd name="T50" fmla="*/ 573 w 1778"/>
                <a:gd name="T51" fmla="*/ 180 h 438"/>
                <a:gd name="T52" fmla="*/ 689 w 1778"/>
                <a:gd name="T53" fmla="*/ 180 h 438"/>
                <a:gd name="T54" fmla="*/ 773 w 1778"/>
                <a:gd name="T55" fmla="*/ 180 h 438"/>
                <a:gd name="T56" fmla="*/ 773 w 1778"/>
                <a:gd name="T57" fmla="*/ 206 h 438"/>
                <a:gd name="T58" fmla="*/ 793 w 1778"/>
                <a:gd name="T59" fmla="*/ 206 h 438"/>
                <a:gd name="T60" fmla="*/ 921 w 1778"/>
                <a:gd name="T61" fmla="*/ 206 h 438"/>
                <a:gd name="T62" fmla="*/ 934 w 1778"/>
                <a:gd name="T63" fmla="*/ 206 h 438"/>
                <a:gd name="T64" fmla="*/ 960 w 1778"/>
                <a:gd name="T65" fmla="*/ 206 h 438"/>
                <a:gd name="T66" fmla="*/ 960 w 1778"/>
                <a:gd name="T67" fmla="*/ 238 h 438"/>
                <a:gd name="T68" fmla="*/ 1005 w 1778"/>
                <a:gd name="T69" fmla="*/ 238 h 438"/>
                <a:gd name="T70" fmla="*/ 1005 w 1778"/>
                <a:gd name="T71" fmla="*/ 264 h 438"/>
                <a:gd name="T72" fmla="*/ 1044 w 1778"/>
                <a:gd name="T73" fmla="*/ 264 h 438"/>
                <a:gd name="T74" fmla="*/ 1186 w 1778"/>
                <a:gd name="T75" fmla="*/ 264 h 438"/>
                <a:gd name="T76" fmla="*/ 1205 w 1778"/>
                <a:gd name="T77" fmla="*/ 264 h 438"/>
                <a:gd name="T78" fmla="*/ 1205 w 1778"/>
                <a:gd name="T79" fmla="*/ 296 h 438"/>
                <a:gd name="T80" fmla="*/ 1282 w 1778"/>
                <a:gd name="T81" fmla="*/ 296 h 438"/>
                <a:gd name="T82" fmla="*/ 1321 w 1778"/>
                <a:gd name="T83" fmla="*/ 296 h 438"/>
                <a:gd name="T84" fmla="*/ 1469 w 1778"/>
                <a:gd name="T85" fmla="*/ 296 h 438"/>
                <a:gd name="T86" fmla="*/ 1469 w 1778"/>
                <a:gd name="T87" fmla="*/ 328 h 438"/>
                <a:gd name="T88" fmla="*/ 1611 w 1778"/>
                <a:gd name="T89" fmla="*/ 328 h 438"/>
                <a:gd name="T90" fmla="*/ 1611 w 1778"/>
                <a:gd name="T91" fmla="*/ 367 h 438"/>
                <a:gd name="T92" fmla="*/ 1637 w 1778"/>
                <a:gd name="T93" fmla="*/ 367 h 438"/>
                <a:gd name="T94" fmla="*/ 1714 w 1778"/>
                <a:gd name="T95" fmla="*/ 367 h 438"/>
                <a:gd name="T96" fmla="*/ 1714 w 1778"/>
                <a:gd name="T97" fmla="*/ 399 h 438"/>
                <a:gd name="T98" fmla="*/ 1759 w 1778"/>
                <a:gd name="T99" fmla="*/ 399 h 438"/>
                <a:gd name="T100" fmla="*/ 1765 w 1778"/>
                <a:gd name="T101" fmla="*/ 399 h 438"/>
                <a:gd name="T102" fmla="*/ 1765 w 1778"/>
                <a:gd name="T103" fmla="*/ 438 h 438"/>
                <a:gd name="T104" fmla="*/ 1778 w 1778"/>
                <a:gd name="T105" fmla="*/ 438 h 4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1778" h="438">
                  <a:moveTo>
                    <a:pt x="0" y="0"/>
                  </a:moveTo>
                  <a:lnTo>
                    <a:pt x="13" y="0"/>
                  </a:lnTo>
                  <a:lnTo>
                    <a:pt x="13" y="19"/>
                  </a:lnTo>
                  <a:lnTo>
                    <a:pt x="26" y="19"/>
                  </a:lnTo>
                  <a:lnTo>
                    <a:pt x="45" y="19"/>
                  </a:lnTo>
                  <a:lnTo>
                    <a:pt x="64" y="19"/>
                  </a:lnTo>
                  <a:lnTo>
                    <a:pt x="64" y="38"/>
                  </a:lnTo>
                  <a:lnTo>
                    <a:pt x="168" y="38"/>
                  </a:lnTo>
                  <a:lnTo>
                    <a:pt x="168" y="64"/>
                  </a:lnTo>
                  <a:lnTo>
                    <a:pt x="284" y="64"/>
                  </a:lnTo>
                  <a:lnTo>
                    <a:pt x="329" y="64"/>
                  </a:lnTo>
                  <a:lnTo>
                    <a:pt x="342" y="64"/>
                  </a:lnTo>
                  <a:lnTo>
                    <a:pt x="342" y="83"/>
                  </a:lnTo>
                  <a:lnTo>
                    <a:pt x="354" y="83"/>
                  </a:lnTo>
                  <a:lnTo>
                    <a:pt x="361" y="83"/>
                  </a:lnTo>
                  <a:lnTo>
                    <a:pt x="361" y="109"/>
                  </a:lnTo>
                  <a:lnTo>
                    <a:pt x="393" y="109"/>
                  </a:lnTo>
                  <a:lnTo>
                    <a:pt x="400" y="109"/>
                  </a:lnTo>
                  <a:lnTo>
                    <a:pt x="400" y="129"/>
                  </a:lnTo>
                  <a:lnTo>
                    <a:pt x="406" y="129"/>
                  </a:lnTo>
                  <a:lnTo>
                    <a:pt x="406" y="154"/>
                  </a:lnTo>
                  <a:lnTo>
                    <a:pt x="432" y="154"/>
                  </a:lnTo>
                  <a:lnTo>
                    <a:pt x="438" y="154"/>
                  </a:lnTo>
                  <a:lnTo>
                    <a:pt x="554" y="154"/>
                  </a:lnTo>
                  <a:lnTo>
                    <a:pt x="573" y="154"/>
                  </a:lnTo>
                  <a:lnTo>
                    <a:pt x="573" y="180"/>
                  </a:lnTo>
                  <a:lnTo>
                    <a:pt x="689" y="180"/>
                  </a:lnTo>
                  <a:lnTo>
                    <a:pt x="773" y="180"/>
                  </a:lnTo>
                  <a:lnTo>
                    <a:pt x="773" y="206"/>
                  </a:lnTo>
                  <a:lnTo>
                    <a:pt x="793" y="206"/>
                  </a:lnTo>
                  <a:lnTo>
                    <a:pt x="921" y="206"/>
                  </a:lnTo>
                  <a:lnTo>
                    <a:pt x="934" y="206"/>
                  </a:lnTo>
                  <a:lnTo>
                    <a:pt x="960" y="206"/>
                  </a:lnTo>
                  <a:lnTo>
                    <a:pt x="960" y="238"/>
                  </a:lnTo>
                  <a:lnTo>
                    <a:pt x="1005" y="238"/>
                  </a:lnTo>
                  <a:lnTo>
                    <a:pt x="1005" y="264"/>
                  </a:lnTo>
                  <a:lnTo>
                    <a:pt x="1044" y="264"/>
                  </a:lnTo>
                  <a:lnTo>
                    <a:pt x="1186" y="264"/>
                  </a:lnTo>
                  <a:lnTo>
                    <a:pt x="1205" y="264"/>
                  </a:lnTo>
                  <a:lnTo>
                    <a:pt x="1205" y="296"/>
                  </a:lnTo>
                  <a:lnTo>
                    <a:pt x="1282" y="296"/>
                  </a:lnTo>
                  <a:lnTo>
                    <a:pt x="1321" y="296"/>
                  </a:lnTo>
                  <a:lnTo>
                    <a:pt x="1469" y="296"/>
                  </a:lnTo>
                  <a:lnTo>
                    <a:pt x="1469" y="328"/>
                  </a:lnTo>
                  <a:lnTo>
                    <a:pt x="1611" y="328"/>
                  </a:lnTo>
                  <a:lnTo>
                    <a:pt x="1611" y="367"/>
                  </a:lnTo>
                  <a:lnTo>
                    <a:pt x="1637" y="367"/>
                  </a:lnTo>
                  <a:lnTo>
                    <a:pt x="1714" y="367"/>
                  </a:lnTo>
                  <a:lnTo>
                    <a:pt x="1714" y="399"/>
                  </a:lnTo>
                  <a:lnTo>
                    <a:pt x="1759" y="399"/>
                  </a:lnTo>
                  <a:lnTo>
                    <a:pt x="1765" y="399"/>
                  </a:lnTo>
                  <a:lnTo>
                    <a:pt x="1765" y="438"/>
                  </a:lnTo>
                  <a:lnTo>
                    <a:pt x="1778" y="438"/>
                  </a:lnTo>
                </a:path>
              </a:pathLst>
            </a:custGeom>
            <a:noFill/>
            <a:ln w="19050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Line 30">
              <a:extLst>
                <a:ext uri="{FF2B5EF4-FFF2-40B4-BE49-F238E27FC236}">
                  <a16:creationId xmlns:a16="http://schemas.microsoft.com/office/drawing/2014/main" id="{44A0A9F0-5EFF-486D-8614-DD194D15EE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8538" y="2063751"/>
              <a:ext cx="0" cy="1841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Line 31">
              <a:extLst>
                <a:ext uri="{FF2B5EF4-FFF2-40B4-BE49-F238E27FC236}">
                  <a16:creationId xmlns:a16="http://schemas.microsoft.com/office/drawing/2014/main" id="{5EA6E2C5-E00A-4FBB-9DC9-FD1D984DC9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98538" y="3905251"/>
              <a:ext cx="28225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49" name="Line 32">
              <a:extLst>
                <a:ext uri="{FF2B5EF4-FFF2-40B4-BE49-F238E27FC236}">
                  <a16:creationId xmlns:a16="http://schemas.microsoft.com/office/drawing/2014/main" id="{A9C74389-C1F0-4A6D-B2E5-E15EFB1E40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8538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Rectangle 33">
              <a:extLst>
                <a:ext uri="{FF2B5EF4-FFF2-40B4-BE49-F238E27FC236}">
                  <a16:creationId xmlns:a16="http://schemas.microsoft.com/office/drawing/2014/main" id="{E12A9E77-46D9-4EEC-AE80-340EF83F72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7263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Line 34">
              <a:extLst>
                <a:ext uri="{FF2B5EF4-FFF2-40B4-BE49-F238E27FC236}">
                  <a16:creationId xmlns:a16="http://schemas.microsoft.com/office/drawing/2014/main" id="{2AA5CA92-9FF3-4946-9AF2-40B990CB1A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4288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2" name="Line 35">
              <a:extLst>
                <a:ext uri="{FF2B5EF4-FFF2-40B4-BE49-F238E27FC236}">
                  <a16:creationId xmlns:a16="http://schemas.microsoft.com/office/drawing/2014/main" id="{4359B249-7E9E-41CA-A38D-EDA31A7050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0513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3" name="Rectangle 36">
              <a:extLst>
                <a:ext uri="{FF2B5EF4-FFF2-40B4-BE49-F238E27FC236}">
                  <a16:creationId xmlns:a16="http://schemas.microsoft.com/office/drawing/2014/main" id="{B2AF83AF-4EE1-4C8D-B25C-9FC276777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0825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Line 37">
              <a:extLst>
                <a:ext uri="{FF2B5EF4-FFF2-40B4-BE49-F238E27FC236}">
                  <a16:creationId xmlns:a16="http://schemas.microsoft.com/office/drawing/2014/main" id="{4453EDCB-DD99-420E-9FC1-3F3DAF0CC9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7850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55" name="Line 38">
              <a:extLst>
                <a:ext uri="{FF2B5EF4-FFF2-40B4-BE49-F238E27FC236}">
                  <a16:creationId xmlns:a16="http://schemas.microsoft.com/office/drawing/2014/main" id="{983F2F58-ABC4-4AE2-97D0-B9B9672297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4075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48" name="Rectangle 39">
              <a:extLst>
                <a:ext uri="{FF2B5EF4-FFF2-40B4-BE49-F238E27FC236}">
                  <a16:creationId xmlns:a16="http://schemas.microsoft.com/office/drawing/2014/main" id="{D970E584-908D-4454-A071-5E6F2A1AF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2800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Line 40">
              <a:extLst>
                <a:ext uri="{FF2B5EF4-FFF2-40B4-BE49-F238E27FC236}">
                  <a16:creationId xmlns:a16="http://schemas.microsoft.com/office/drawing/2014/main" id="{0643F4F2-FAC0-45D1-B459-F039E8DA6D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9825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0" name="Line 41">
              <a:extLst>
                <a:ext uri="{FF2B5EF4-FFF2-40B4-BE49-F238E27FC236}">
                  <a16:creationId xmlns:a16="http://schemas.microsoft.com/office/drawing/2014/main" id="{F2019257-3559-48EF-9FF7-2671EC7FF6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7163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1" name="Rectangle 42">
              <a:extLst>
                <a:ext uri="{FF2B5EF4-FFF2-40B4-BE49-F238E27FC236}">
                  <a16:creationId xmlns:a16="http://schemas.microsoft.com/office/drawing/2014/main" id="{79E1F38C-CAFF-4C2F-B2CF-D87C312BBD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5888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2" name="Line 43">
              <a:extLst>
                <a:ext uri="{FF2B5EF4-FFF2-40B4-BE49-F238E27FC236}">
                  <a16:creationId xmlns:a16="http://schemas.microsoft.com/office/drawing/2014/main" id="{F878C105-D111-46D4-B8CA-634F38531B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3388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453" name="Line 44">
              <a:extLst>
                <a:ext uri="{FF2B5EF4-FFF2-40B4-BE49-F238E27FC236}">
                  <a16:creationId xmlns:a16="http://schemas.microsoft.com/office/drawing/2014/main" id="{08C96BE3-72AA-44C9-9C6E-7387445AF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9138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2" name="Rectangle 45">
              <a:extLst>
                <a:ext uri="{FF2B5EF4-FFF2-40B4-BE49-F238E27FC236}">
                  <a16:creationId xmlns:a16="http://schemas.microsoft.com/office/drawing/2014/main" id="{9931EAEA-73AD-4711-BCAF-9F379DC90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7863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Line 46">
              <a:extLst>
                <a:ext uri="{FF2B5EF4-FFF2-40B4-BE49-F238E27FC236}">
                  <a16:creationId xmlns:a16="http://schemas.microsoft.com/office/drawing/2014/main" id="{E9D8E2AA-0485-485E-989D-88922E125D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5363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4" name="Line 47">
              <a:extLst>
                <a:ext uri="{FF2B5EF4-FFF2-40B4-BE49-F238E27FC236}">
                  <a16:creationId xmlns:a16="http://schemas.microsoft.com/office/drawing/2014/main" id="{E4DA0782-09C4-4701-B5D1-3212422856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1113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65" name="Rectangle 48">
              <a:extLst>
                <a:ext uri="{FF2B5EF4-FFF2-40B4-BE49-F238E27FC236}">
                  <a16:creationId xmlns:a16="http://schemas.microsoft.com/office/drawing/2014/main" id="{BD9CEB1F-DC0B-4858-935C-495976BAA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1425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68" name="グループ化 2367">
            <a:extLst>
              <a:ext uri="{FF2B5EF4-FFF2-40B4-BE49-F238E27FC236}">
                <a16:creationId xmlns:a16="http://schemas.microsoft.com/office/drawing/2014/main" id="{38020DFD-9B58-43AC-B2A2-0957BA2970CE}"/>
              </a:ext>
            </a:extLst>
          </p:cNvPr>
          <p:cNvGrpSpPr/>
          <p:nvPr/>
        </p:nvGrpSpPr>
        <p:grpSpPr>
          <a:xfrm>
            <a:off x="4716554" y="1066602"/>
            <a:ext cx="3137768" cy="2222044"/>
            <a:chOff x="4622800" y="1970088"/>
            <a:chExt cx="3137768" cy="2222044"/>
          </a:xfrm>
        </p:grpSpPr>
        <p:sp>
          <p:nvSpPr>
            <p:cNvPr id="277" name="Line 55">
              <a:extLst>
                <a:ext uri="{FF2B5EF4-FFF2-40B4-BE49-F238E27FC236}">
                  <a16:creationId xmlns:a16="http://schemas.microsoft.com/office/drawing/2014/main" id="{A8BE4C31-21A4-4311-A20F-EC3A6D5044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39052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56">
              <a:extLst>
                <a:ext uri="{FF2B5EF4-FFF2-40B4-BE49-F238E27FC236}">
                  <a16:creationId xmlns:a16="http://schemas.microsoft.com/office/drawing/2014/main" id="{647B34E6-BB97-46F5-8E1B-7E7F2ACDB7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38131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Line 57">
              <a:extLst>
                <a:ext uri="{FF2B5EF4-FFF2-40B4-BE49-F238E27FC236}">
                  <a16:creationId xmlns:a16="http://schemas.microsoft.com/office/drawing/2014/main" id="{49B438E3-B067-4E8B-ADC0-09334D6773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57750" y="37211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Line 58">
              <a:extLst>
                <a:ext uri="{FF2B5EF4-FFF2-40B4-BE49-F238E27FC236}">
                  <a16:creationId xmlns:a16="http://schemas.microsoft.com/office/drawing/2014/main" id="{A11062FE-A295-43E2-92C3-FE386E1B9A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35369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Rectangle 59">
              <a:extLst>
                <a:ext uri="{FF2B5EF4-FFF2-40B4-BE49-F238E27FC236}">
                  <a16:creationId xmlns:a16="http://schemas.microsoft.com/office/drawing/2014/main" id="{8A348991-1B23-45C3-898F-F80B213B83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34448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Line 60">
              <a:extLst>
                <a:ext uri="{FF2B5EF4-FFF2-40B4-BE49-F238E27FC236}">
                  <a16:creationId xmlns:a16="http://schemas.microsoft.com/office/drawing/2014/main" id="{DC295DAF-03F0-4DBA-A92A-89D0DBCD22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57750" y="33528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Line 61">
              <a:extLst>
                <a:ext uri="{FF2B5EF4-FFF2-40B4-BE49-F238E27FC236}">
                  <a16:creationId xmlns:a16="http://schemas.microsoft.com/office/drawing/2014/main" id="{E80E0DB2-23F9-4714-9EE6-27F85A5E63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31686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Rectangle 62">
              <a:extLst>
                <a:ext uri="{FF2B5EF4-FFF2-40B4-BE49-F238E27FC236}">
                  <a16:creationId xmlns:a16="http://schemas.microsoft.com/office/drawing/2014/main" id="{BAFD5FB7-AC5D-4D62-876C-F4283C973B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30765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Line 63">
              <a:extLst>
                <a:ext uri="{FF2B5EF4-FFF2-40B4-BE49-F238E27FC236}">
                  <a16:creationId xmlns:a16="http://schemas.microsoft.com/office/drawing/2014/main" id="{080F1E57-EACB-405A-8E85-44EF579C94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57750" y="29845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Line 64">
              <a:extLst>
                <a:ext uri="{FF2B5EF4-FFF2-40B4-BE49-F238E27FC236}">
                  <a16:creationId xmlns:a16="http://schemas.microsoft.com/office/drawing/2014/main" id="{BC49B3FF-B6A5-4E6E-AB4F-2AC43155C2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28003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65">
              <a:extLst>
                <a:ext uri="{FF2B5EF4-FFF2-40B4-BE49-F238E27FC236}">
                  <a16:creationId xmlns:a16="http://schemas.microsoft.com/office/drawing/2014/main" id="{298D2026-E8BC-4CE3-84CA-14044DD74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27082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Line 66">
              <a:extLst>
                <a:ext uri="{FF2B5EF4-FFF2-40B4-BE49-F238E27FC236}">
                  <a16:creationId xmlns:a16="http://schemas.microsoft.com/office/drawing/2014/main" id="{71742699-C41E-4E20-9667-0BC7E7551F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57750" y="26162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67">
              <a:extLst>
                <a:ext uri="{FF2B5EF4-FFF2-40B4-BE49-F238E27FC236}">
                  <a16:creationId xmlns:a16="http://schemas.microsoft.com/office/drawing/2014/main" id="{B148EF67-B967-4EE1-BB1B-61B3C52467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24320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68">
              <a:extLst>
                <a:ext uri="{FF2B5EF4-FFF2-40B4-BE49-F238E27FC236}">
                  <a16:creationId xmlns:a16="http://schemas.microsoft.com/office/drawing/2014/main" id="{E7E3704D-78AB-4DC8-8AE1-87A8E64D4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233997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Line 69">
              <a:extLst>
                <a:ext uri="{FF2B5EF4-FFF2-40B4-BE49-F238E27FC236}">
                  <a16:creationId xmlns:a16="http://schemas.microsoft.com/office/drawing/2014/main" id="{C09DEFF6-B4B9-4DBA-9346-54521B05DB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57750" y="2247901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Line 70">
              <a:extLst>
                <a:ext uri="{FF2B5EF4-FFF2-40B4-BE49-F238E27FC236}">
                  <a16:creationId xmlns:a16="http://schemas.microsoft.com/office/drawing/2014/main" id="{B1A3F024-422B-4590-B996-EF98F2522E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6000" y="2063751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71">
              <a:extLst>
                <a:ext uri="{FF2B5EF4-FFF2-40B4-BE49-F238E27FC236}">
                  <a16:creationId xmlns:a16="http://schemas.microsoft.com/office/drawing/2014/main" id="{A08129B3-32E1-4BBD-A7C2-934950D334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2800" y="197008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Freeform 76">
              <a:extLst>
                <a:ext uri="{FF2B5EF4-FFF2-40B4-BE49-F238E27FC236}">
                  <a16:creationId xmlns:a16="http://schemas.microsoft.com/office/drawing/2014/main" id="{BCE0B05A-9564-430B-BC28-04785B2C662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7913" y="2063751"/>
              <a:ext cx="2822575" cy="1289050"/>
            </a:xfrm>
            <a:custGeom>
              <a:avLst/>
              <a:gdLst>
                <a:gd name="T0" fmla="*/ 26 w 1778"/>
                <a:gd name="T1" fmla="*/ 0 h 812"/>
                <a:gd name="T2" fmla="*/ 45 w 1778"/>
                <a:gd name="T3" fmla="*/ 19 h 812"/>
                <a:gd name="T4" fmla="*/ 58 w 1778"/>
                <a:gd name="T5" fmla="*/ 38 h 812"/>
                <a:gd name="T6" fmla="*/ 58 w 1778"/>
                <a:gd name="T7" fmla="*/ 77 h 812"/>
                <a:gd name="T8" fmla="*/ 84 w 1778"/>
                <a:gd name="T9" fmla="*/ 96 h 812"/>
                <a:gd name="T10" fmla="*/ 90 w 1778"/>
                <a:gd name="T11" fmla="*/ 116 h 812"/>
                <a:gd name="T12" fmla="*/ 90 w 1778"/>
                <a:gd name="T13" fmla="*/ 154 h 812"/>
                <a:gd name="T14" fmla="*/ 90 w 1778"/>
                <a:gd name="T15" fmla="*/ 193 h 812"/>
                <a:gd name="T16" fmla="*/ 97 w 1778"/>
                <a:gd name="T17" fmla="*/ 212 h 812"/>
                <a:gd name="T18" fmla="*/ 103 w 1778"/>
                <a:gd name="T19" fmla="*/ 225 h 812"/>
                <a:gd name="T20" fmla="*/ 110 w 1778"/>
                <a:gd name="T21" fmla="*/ 245 h 812"/>
                <a:gd name="T22" fmla="*/ 116 w 1778"/>
                <a:gd name="T23" fmla="*/ 264 h 812"/>
                <a:gd name="T24" fmla="*/ 148 w 1778"/>
                <a:gd name="T25" fmla="*/ 283 h 812"/>
                <a:gd name="T26" fmla="*/ 155 w 1778"/>
                <a:gd name="T27" fmla="*/ 322 h 812"/>
                <a:gd name="T28" fmla="*/ 174 w 1778"/>
                <a:gd name="T29" fmla="*/ 341 h 812"/>
                <a:gd name="T30" fmla="*/ 187 w 1778"/>
                <a:gd name="T31" fmla="*/ 361 h 812"/>
                <a:gd name="T32" fmla="*/ 206 w 1778"/>
                <a:gd name="T33" fmla="*/ 361 h 812"/>
                <a:gd name="T34" fmla="*/ 206 w 1778"/>
                <a:gd name="T35" fmla="*/ 399 h 812"/>
                <a:gd name="T36" fmla="*/ 258 w 1778"/>
                <a:gd name="T37" fmla="*/ 419 h 812"/>
                <a:gd name="T38" fmla="*/ 271 w 1778"/>
                <a:gd name="T39" fmla="*/ 445 h 812"/>
                <a:gd name="T40" fmla="*/ 290 w 1778"/>
                <a:gd name="T41" fmla="*/ 464 h 812"/>
                <a:gd name="T42" fmla="*/ 296 w 1778"/>
                <a:gd name="T43" fmla="*/ 483 h 812"/>
                <a:gd name="T44" fmla="*/ 309 w 1778"/>
                <a:gd name="T45" fmla="*/ 503 h 812"/>
                <a:gd name="T46" fmla="*/ 342 w 1778"/>
                <a:gd name="T47" fmla="*/ 522 h 812"/>
                <a:gd name="T48" fmla="*/ 400 w 1778"/>
                <a:gd name="T49" fmla="*/ 522 h 812"/>
                <a:gd name="T50" fmla="*/ 425 w 1778"/>
                <a:gd name="T51" fmla="*/ 541 h 812"/>
                <a:gd name="T52" fmla="*/ 580 w 1778"/>
                <a:gd name="T53" fmla="*/ 561 h 812"/>
                <a:gd name="T54" fmla="*/ 773 w 1778"/>
                <a:gd name="T55" fmla="*/ 586 h 812"/>
                <a:gd name="T56" fmla="*/ 786 w 1778"/>
                <a:gd name="T57" fmla="*/ 606 h 812"/>
                <a:gd name="T58" fmla="*/ 915 w 1778"/>
                <a:gd name="T59" fmla="*/ 651 h 812"/>
                <a:gd name="T60" fmla="*/ 934 w 1778"/>
                <a:gd name="T61" fmla="*/ 670 h 812"/>
                <a:gd name="T62" fmla="*/ 999 w 1778"/>
                <a:gd name="T63" fmla="*/ 670 h 812"/>
                <a:gd name="T64" fmla="*/ 1250 w 1778"/>
                <a:gd name="T65" fmla="*/ 690 h 812"/>
                <a:gd name="T66" fmla="*/ 1302 w 1778"/>
                <a:gd name="T67" fmla="*/ 715 h 812"/>
                <a:gd name="T68" fmla="*/ 1379 w 1778"/>
                <a:gd name="T69" fmla="*/ 741 h 812"/>
                <a:gd name="T70" fmla="*/ 1443 w 1778"/>
                <a:gd name="T71" fmla="*/ 761 h 812"/>
                <a:gd name="T72" fmla="*/ 1656 w 1778"/>
                <a:gd name="T73" fmla="*/ 761 h 812"/>
                <a:gd name="T74" fmla="*/ 1682 w 1778"/>
                <a:gd name="T75" fmla="*/ 786 h 812"/>
                <a:gd name="T76" fmla="*/ 1733 w 1778"/>
                <a:gd name="T77" fmla="*/ 812 h 8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1778" h="812">
                  <a:moveTo>
                    <a:pt x="0" y="0"/>
                  </a:moveTo>
                  <a:lnTo>
                    <a:pt x="26" y="0"/>
                  </a:lnTo>
                  <a:lnTo>
                    <a:pt x="26" y="19"/>
                  </a:lnTo>
                  <a:lnTo>
                    <a:pt x="45" y="19"/>
                  </a:lnTo>
                  <a:lnTo>
                    <a:pt x="45" y="38"/>
                  </a:lnTo>
                  <a:lnTo>
                    <a:pt x="58" y="38"/>
                  </a:lnTo>
                  <a:lnTo>
                    <a:pt x="58" y="58"/>
                  </a:lnTo>
                  <a:lnTo>
                    <a:pt x="58" y="77"/>
                  </a:lnTo>
                  <a:lnTo>
                    <a:pt x="84" y="77"/>
                  </a:lnTo>
                  <a:lnTo>
                    <a:pt x="84" y="96"/>
                  </a:lnTo>
                  <a:lnTo>
                    <a:pt x="84" y="116"/>
                  </a:lnTo>
                  <a:lnTo>
                    <a:pt x="90" y="116"/>
                  </a:lnTo>
                  <a:lnTo>
                    <a:pt x="90" y="135"/>
                  </a:lnTo>
                  <a:lnTo>
                    <a:pt x="90" y="154"/>
                  </a:lnTo>
                  <a:lnTo>
                    <a:pt x="90" y="174"/>
                  </a:lnTo>
                  <a:lnTo>
                    <a:pt x="90" y="193"/>
                  </a:lnTo>
                  <a:lnTo>
                    <a:pt x="97" y="193"/>
                  </a:lnTo>
                  <a:lnTo>
                    <a:pt x="97" y="212"/>
                  </a:lnTo>
                  <a:lnTo>
                    <a:pt x="103" y="212"/>
                  </a:lnTo>
                  <a:lnTo>
                    <a:pt x="103" y="225"/>
                  </a:lnTo>
                  <a:lnTo>
                    <a:pt x="110" y="225"/>
                  </a:lnTo>
                  <a:lnTo>
                    <a:pt x="110" y="245"/>
                  </a:lnTo>
                  <a:lnTo>
                    <a:pt x="110" y="264"/>
                  </a:lnTo>
                  <a:lnTo>
                    <a:pt x="116" y="264"/>
                  </a:lnTo>
                  <a:lnTo>
                    <a:pt x="116" y="283"/>
                  </a:lnTo>
                  <a:lnTo>
                    <a:pt x="148" y="283"/>
                  </a:lnTo>
                  <a:lnTo>
                    <a:pt x="148" y="322"/>
                  </a:lnTo>
                  <a:lnTo>
                    <a:pt x="155" y="322"/>
                  </a:lnTo>
                  <a:lnTo>
                    <a:pt x="155" y="341"/>
                  </a:lnTo>
                  <a:lnTo>
                    <a:pt x="174" y="341"/>
                  </a:lnTo>
                  <a:lnTo>
                    <a:pt x="187" y="341"/>
                  </a:lnTo>
                  <a:lnTo>
                    <a:pt x="187" y="361"/>
                  </a:lnTo>
                  <a:lnTo>
                    <a:pt x="193" y="361"/>
                  </a:lnTo>
                  <a:lnTo>
                    <a:pt x="206" y="361"/>
                  </a:lnTo>
                  <a:lnTo>
                    <a:pt x="206" y="380"/>
                  </a:lnTo>
                  <a:lnTo>
                    <a:pt x="206" y="399"/>
                  </a:lnTo>
                  <a:lnTo>
                    <a:pt x="258" y="399"/>
                  </a:lnTo>
                  <a:lnTo>
                    <a:pt x="258" y="419"/>
                  </a:lnTo>
                  <a:lnTo>
                    <a:pt x="271" y="419"/>
                  </a:lnTo>
                  <a:lnTo>
                    <a:pt x="271" y="445"/>
                  </a:lnTo>
                  <a:lnTo>
                    <a:pt x="290" y="445"/>
                  </a:lnTo>
                  <a:lnTo>
                    <a:pt x="290" y="464"/>
                  </a:lnTo>
                  <a:lnTo>
                    <a:pt x="296" y="464"/>
                  </a:lnTo>
                  <a:lnTo>
                    <a:pt x="296" y="483"/>
                  </a:lnTo>
                  <a:lnTo>
                    <a:pt x="309" y="483"/>
                  </a:lnTo>
                  <a:lnTo>
                    <a:pt x="309" y="503"/>
                  </a:lnTo>
                  <a:lnTo>
                    <a:pt x="342" y="503"/>
                  </a:lnTo>
                  <a:lnTo>
                    <a:pt x="342" y="522"/>
                  </a:lnTo>
                  <a:lnTo>
                    <a:pt x="354" y="522"/>
                  </a:lnTo>
                  <a:lnTo>
                    <a:pt x="400" y="522"/>
                  </a:lnTo>
                  <a:lnTo>
                    <a:pt x="400" y="541"/>
                  </a:lnTo>
                  <a:lnTo>
                    <a:pt x="425" y="541"/>
                  </a:lnTo>
                  <a:lnTo>
                    <a:pt x="580" y="541"/>
                  </a:lnTo>
                  <a:lnTo>
                    <a:pt x="580" y="561"/>
                  </a:lnTo>
                  <a:lnTo>
                    <a:pt x="773" y="561"/>
                  </a:lnTo>
                  <a:lnTo>
                    <a:pt x="773" y="586"/>
                  </a:lnTo>
                  <a:lnTo>
                    <a:pt x="786" y="586"/>
                  </a:lnTo>
                  <a:lnTo>
                    <a:pt x="786" y="606"/>
                  </a:lnTo>
                  <a:lnTo>
                    <a:pt x="915" y="606"/>
                  </a:lnTo>
                  <a:lnTo>
                    <a:pt x="915" y="651"/>
                  </a:lnTo>
                  <a:lnTo>
                    <a:pt x="934" y="651"/>
                  </a:lnTo>
                  <a:lnTo>
                    <a:pt x="934" y="670"/>
                  </a:lnTo>
                  <a:lnTo>
                    <a:pt x="986" y="670"/>
                  </a:lnTo>
                  <a:lnTo>
                    <a:pt x="999" y="670"/>
                  </a:lnTo>
                  <a:lnTo>
                    <a:pt x="999" y="690"/>
                  </a:lnTo>
                  <a:lnTo>
                    <a:pt x="1250" y="690"/>
                  </a:lnTo>
                  <a:lnTo>
                    <a:pt x="1250" y="715"/>
                  </a:lnTo>
                  <a:lnTo>
                    <a:pt x="1302" y="715"/>
                  </a:lnTo>
                  <a:lnTo>
                    <a:pt x="1379" y="715"/>
                  </a:lnTo>
                  <a:lnTo>
                    <a:pt x="1379" y="741"/>
                  </a:lnTo>
                  <a:lnTo>
                    <a:pt x="1443" y="741"/>
                  </a:lnTo>
                  <a:lnTo>
                    <a:pt x="1443" y="761"/>
                  </a:lnTo>
                  <a:lnTo>
                    <a:pt x="1592" y="761"/>
                  </a:lnTo>
                  <a:lnTo>
                    <a:pt x="1656" y="761"/>
                  </a:lnTo>
                  <a:lnTo>
                    <a:pt x="1656" y="786"/>
                  </a:lnTo>
                  <a:lnTo>
                    <a:pt x="1682" y="786"/>
                  </a:lnTo>
                  <a:lnTo>
                    <a:pt x="1682" y="812"/>
                  </a:lnTo>
                  <a:lnTo>
                    <a:pt x="1733" y="812"/>
                  </a:lnTo>
                  <a:lnTo>
                    <a:pt x="1778" y="812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Freeform 77">
              <a:extLst>
                <a:ext uri="{FF2B5EF4-FFF2-40B4-BE49-F238E27FC236}">
                  <a16:creationId xmlns:a16="http://schemas.microsoft.com/office/drawing/2014/main" id="{A2F7BFF6-D261-4547-9DF7-660643970A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7913" y="2063751"/>
              <a:ext cx="2822575" cy="1576388"/>
            </a:xfrm>
            <a:custGeom>
              <a:avLst/>
              <a:gdLst>
                <a:gd name="T0" fmla="*/ 0 w 1778"/>
                <a:gd name="T1" fmla="*/ 0 h 993"/>
                <a:gd name="T2" fmla="*/ 26 w 1778"/>
                <a:gd name="T3" fmla="*/ 19 h 993"/>
                <a:gd name="T4" fmla="*/ 32 w 1778"/>
                <a:gd name="T5" fmla="*/ 38 h 993"/>
                <a:gd name="T6" fmla="*/ 39 w 1778"/>
                <a:gd name="T7" fmla="*/ 58 h 993"/>
                <a:gd name="T8" fmla="*/ 45 w 1778"/>
                <a:gd name="T9" fmla="*/ 71 h 993"/>
                <a:gd name="T10" fmla="*/ 64 w 1778"/>
                <a:gd name="T11" fmla="*/ 90 h 993"/>
                <a:gd name="T12" fmla="*/ 64 w 1778"/>
                <a:gd name="T13" fmla="*/ 129 h 993"/>
                <a:gd name="T14" fmla="*/ 71 w 1778"/>
                <a:gd name="T15" fmla="*/ 167 h 993"/>
                <a:gd name="T16" fmla="*/ 77 w 1778"/>
                <a:gd name="T17" fmla="*/ 187 h 993"/>
                <a:gd name="T18" fmla="*/ 90 w 1778"/>
                <a:gd name="T19" fmla="*/ 238 h 993"/>
                <a:gd name="T20" fmla="*/ 103 w 1778"/>
                <a:gd name="T21" fmla="*/ 258 h 993"/>
                <a:gd name="T22" fmla="*/ 110 w 1778"/>
                <a:gd name="T23" fmla="*/ 277 h 993"/>
                <a:gd name="T24" fmla="*/ 129 w 1778"/>
                <a:gd name="T25" fmla="*/ 316 h 993"/>
                <a:gd name="T26" fmla="*/ 135 w 1778"/>
                <a:gd name="T27" fmla="*/ 328 h 993"/>
                <a:gd name="T28" fmla="*/ 148 w 1778"/>
                <a:gd name="T29" fmla="*/ 348 h 993"/>
                <a:gd name="T30" fmla="*/ 155 w 1778"/>
                <a:gd name="T31" fmla="*/ 367 h 993"/>
                <a:gd name="T32" fmla="*/ 161 w 1778"/>
                <a:gd name="T33" fmla="*/ 387 h 993"/>
                <a:gd name="T34" fmla="*/ 161 w 1778"/>
                <a:gd name="T35" fmla="*/ 425 h 993"/>
                <a:gd name="T36" fmla="*/ 174 w 1778"/>
                <a:gd name="T37" fmla="*/ 445 h 993"/>
                <a:gd name="T38" fmla="*/ 180 w 1778"/>
                <a:gd name="T39" fmla="*/ 457 h 993"/>
                <a:gd name="T40" fmla="*/ 193 w 1778"/>
                <a:gd name="T41" fmla="*/ 457 h 993"/>
                <a:gd name="T42" fmla="*/ 206 w 1778"/>
                <a:gd name="T43" fmla="*/ 477 h 993"/>
                <a:gd name="T44" fmla="*/ 213 w 1778"/>
                <a:gd name="T45" fmla="*/ 496 h 993"/>
                <a:gd name="T46" fmla="*/ 213 w 1778"/>
                <a:gd name="T47" fmla="*/ 535 h 993"/>
                <a:gd name="T48" fmla="*/ 219 w 1778"/>
                <a:gd name="T49" fmla="*/ 554 h 993"/>
                <a:gd name="T50" fmla="*/ 238 w 1778"/>
                <a:gd name="T51" fmla="*/ 574 h 993"/>
                <a:gd name="T52" fmla="*/ 245 w 1778"/>
                <a:gd name="T53" fmla="*/ 593 h 993"/>
                <a:gd name="T54" fmla="*/ 277 w 1778"/>
                <a:gd name="T55" fmla="*/ 612 h 993"/>
                <a:gd name="T56" fmla="*/ 277 w 1778"/>
                <a:gd name="T57" fmla="*/ 651 h 993"/>
                <a:gd name="T58" fmla="*/ 290 w 1778"/>
                <a:gd name="T59" fmla="*/ 670 h 993"/>
                <a:gd name="T60" fmla="*/ 296 w 1778"/>
                <a:gd name="T61" fmla="*/ 690 h 993"/>
                <a:gd name="T62" fmla="*/ 303 w 1778"/>
                <a:gd name="T63" fmla="*/ 709 h 993"/>
                <a:gd name="T64" fmla="*/ 354 w 1778"/>
                <a:gd name="T65" fmla="*/ 709 h 993"/>
                <a:gd name="T66" fmla="*/ 361 w 1778"/>
                <a:gd name="T67" fmla="*/ 728 h 993"/>
                <a:gd name="T68" fmla="*/ 419 w 1778"/>
                <a:gd name="T69" fmla="*/ 748 h 993"/>
                <a:gd name="T70" fmla="*/ 438 w 1778"/>
                <a:gd name="T71" fmla="*/ 767 h 993"/>
                <a:gd name="T72" fmla="*/ 470 w 1778"/>
                <a:gd name="T73" fmla="*/ 786 h 993"/>
                <a:gd name="T74" fmla="*/ 477 w 1778"/>
                <a:gd name="T75" fmla="*/ 806 h 993"/>
                <a:gd name="T76" fmla="*/ 490 w 1778"/>
                <a:gd name="T77" fmla="*/ 825 h 993"/>
                <a:gd name="T78" fmla="*/ 561 w 1778"/>
                <a:gd name="T79" fmla="*/ 844 h 993"/>
                <a:gd name="T80" fmla="*/ 747 w 1778"/>
                <a:gd name="T81" fmla="*/ 864 h 993"/>
                <a:gd name="T82" fmla="*/ 805 w 1778"/>
                <a:gd name="T83" fmla="*/ 883 h 993"/>
                <a:gd name="T84" fmla="*/ 889 w 1778"/>
                <a:gd name="T85" fmla="*/ 902 h 993"/>
                <a:gd name="T86" fmla="*/ 915 w 1778"/>
                <a:gd name="T87" fmla="*/ 922 h 993"/>
                <a:gd name="T88" fmla="*/ 1012 w 1778"/>
                <a:gd name="T89" fmla="*/ 948 h 993"/>
                <a:gd name="T90" fmla="*/ 1031 w 1778"/>
                <a:gd name="T91" fmla="*/ 967 h 993"/>
                <a:gd name="T92" fmla="*/ 1231 w 1778"/>
                <a:gd name="T93" fmla="*/ 967 h 993"/>
                <a:gd name="T94" fmla="*/ 1778 w 1778"/>
                <a:gd name="T95" fmla="*/ 993 h 9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778" h="993">
                  <a:moveTo>
                    <a:pt x="0" y="0"/>
                  </a:moveTo>
                  <a:lnTo>
                    <a:pt x="0" y="0"/>
                  </a:lnTo>
                  <a:lnTo>
                    <a:pt x="0" y="19"/>
                  </a:lnTo>
                  <a:lnTo>
                    <a:pt x="26" y="19"/>
                  </a:lnTo>
                  <a:lnTo>
                    <a:pt x="26" y="38"/>
                  </a:lnTo>
                  <a:lnTo>
                    <a:pt x="32" y="38"/>
                  </a:lnTo>
                  <a:lnTo>
                    <a:pt x="32" y="58"/>
                  </a:lnTo>
                  <a:lnTo>
                    <a:pt x="39" y="58"/>
                  </a:lnTo>
                  <a:lnTo>
                    <a:pt x="39" y="71"/>
                  </a:lnTo>
                  <a:lnTo>
                    <a:pt x="45" y="71"/>
                  </a:lnTo>
                  <a:lnTo>
                    <a:pt x="45" y="90"/>
                  </a:lnTo>
                  <a:lnTo>
                    <a:pt x="64" y="90"/>
                  </a:lnTo>
                  <a:lnTo>
                    <a:pt x="64" y="109"/>
                  </a:lnTo>
                  <a:lnTo>
                    <a:pt x="64" y="129"/>
                  </a:lnTo>
                  <a:lnTo>
                    <a:pt x="71" y="129"/>
                  </a:lnTo>
                  <a:lnTo>
                    <a:pt x="71" y="167"/>
                  </a:lnTo>
                  <a:lnTo>
                    <a:pt x="77" y="167"/>
                  </a:lnTo>
                  <a:lnTo>
                    <a:pt x="77" y="187"/>
                  </a:lnTo>
                  <a:lnTo>
                    <a:pt x="90" y="187"/>
                  </a:lnTo>
                  <a:lnTo>
                    <a:pt x="90" y="238"/>
                  </a:lnTo>
                  <a:lnTo>
                    <a:pt x="103" y="238"/>
                  </a:lnTo>
                  <a:lnTo>
                    <a:pt x="103" y="258"/>
                  </a:lnTo>
                  <a:lnTo>
                    <a:pt x="103" y="277"/>
                  </a:lnTo>
                  <a:lnTo>
                    <a:pt x="110" y="277"/>
                  </a:lnTo>
                  <a:lnTo>
                    <a:pt x="110" y="316"/>
                  </a:lnTo>
                  <a:lnTo>
                    <a:pt x="129" y="316"/>
                  </a:lnTo>
                  <a:lnTo>
                    <a:pt x="129" y="328"/>
                  </a:lnTo>
                  <a:lnTo>
                    <a:pt x="135" y="328"/>
                  </a:lnTo>
                  <a:lnTo>
                    <a:pt x="135" y="348"/>
                  </a:lnTo>
                  <a:lnTo>
                    <a:pt x="148" y="348"/>
                  </a:lnTo>
                  <a:lnTo>
                    <a:pt x="148" y="367"/>
                  </a:lnTo>
                  <a:lnTo>
                    <a:pt x="155" y="367"/>
                  </a:lnTo>
                  <a:lnTo>
                    <a:pt x="155" y="387"/>
                  </a:lnTo>
                  <a:lnTo>
                    <a:pt x="161" y="387"/>
                  </a:lnTo>
                  <a:lnTo>
                    <a:pt x="161" y="406"/>
                  </a:lnTo>
                  <a:lnTo>
                    <a:pt x="161" y="425"/>
                  </a:lnTo>
                  <a:lnTo>
                    <a:pt x="174" y="425"/>
                  </a:lnTo>
                  <a:lnTo>
                    <a:pt x="174" y="445"/>
                  </a:lnTo>
                  <a:lnTo>
                    <a:pt x="180" y="445"/>
                  </a:lnTo>
                  <a:lnTo>
                    <a:pt x="180" y="457"/>
                  </a:lnTo>
                  <a:lnTo>
                    <a:pt x="187" y="457"/>
                  </a:lnTo>
                  <a:lnTo>
                    <a:pt x="193" y="457"/>
                  </a:lnTo>
                  <a:lnTo>
                    <a:pt x="193" y="477"/>
                  </a:lnTo>
                  <a:lnTo>
                    <a:pt x="206" y="477"/>
                  </a:lnTo>
                  <a:lnTo>
                    <a:pt x="206" y="496"/>
                  </a:lnTo>
                  <a:lnTo>
                    <a:pt x="213" y="496"/>
                  </a:lnTo>
                  <a:lnTo>
                    <a:pt x="213" y="515"/>
                  </a:lnTo>
                  <a:lnTo>
                    <a:pt x="213" y="535"/>
                  </a:lnTo>
                  <a:lnTo>
                    <a:pt x="219" y="535"/>
                  </a:lnTo>
                  <a:lnTo>
                    <a:pt x="219" y="554"/>
                  </a:lnTo>
                  <a:lnTo>
                    <a:pt x="238" y="554"/>
                  </a:lnTo>
                  <a:lnTo>
                    <a:pt x="238" y="574"/>
                  </a:lnTo>
                  <a:lnTo>
                    <a:pt x="245" y="574"/>
                  </a:lnTo>
                  <a:lnTo>
                    <a:pt x="245" y="593"/>
                  </a:lnTo>
                  <a:lnTo>
                    <a:pt x="245" y="612"/>
                  </a:lnTo>
                  <a:lnTo>
                    <a:pt x="277" y="612"/>
                  </a:lnTo>
                  <a:lnTo>
                    <a:pt x="277" y="632"/>
                  </a:lnTo>
                  <a:lnTo>
                    <a:pt x="277" y="651"/>
                  </a:lnTo>
                  <a:lnTo>
                    <a:pt x="290" y="651"/>
                  </a:lnTo>
                  <a:lnTo>
                    <a:pt x="290" y="670"/>
                  </a:lnTo>
                  <a:lnTo>
                    <a:pt x="296" y="670"/>
                  </a:lnTo>
                  <a:lnTo>
                    <a:pt x="296" y="690"/>
                  </a:lnTo>
                  <a:lnTo>
                    <a:pt x="303" y="690"/>
                  </a:lnTo>
                  <a:lnTo>
                    <a:pt x="303" y="709"/>
                  </a:lnTo>
                  <a:lnTo>
                    <a:pt x="335" y="709"/>
                  </a:lnTo>
                  <a:lnTo>
                    <a:pt x="354" y="709"/>
                  </a:lnTo>
                  <a:lnTo>
                    <a:pt x="354" y="728"/>
                  </a:lnTo>
                  <a:lnTo>
                    <a:pt x="361" y="728"/>
                  </a:lnTo>
                  <a:lnTo>
                    <a:pt x="361" y="748"/>
                  </a:lnTo>
                  <a:lnTo>
                    <a:pt x="419" y="748"/>
                  </a:lnTo>
                  <a:lnTo>
                    <a:pt x="419" y="767"/>
                  </a:lnTo>
                  <a:lnTo>
                    <a:pt x="438" y="767"/>
                  </a:lnTo>
                  <a:lnTo>
                    <a:pt x="438" y="786"/>
                  </a:lnTo>
                  <a:lnTo>
                    <a:pt x="470" y="786"/>
                  </a:lnTo>
                  <a:lnTo>
                    <a:pt x="470" y="806"/>
                  </a:lnTo>
                  <a:lnTo>
                    <a:pt x="477" y="806"/>
                  </a:lnTo>
                  <a:lnTo>
                    <a:pt x="477" y="825"/>
                  </a:lnTo>
                  <a:lnTo>
                    <a:pt x="490" y="825"/>
                  </a:lnTo>
                  <a:lnTo>
                    <a:pt x="490" y="844"/>
                  </a:lnTo>
                  <a:lnTo>
                    <a:pt x="561" y="844"/>
                  </a:lnTo>
                  <a:lnTo>
                    <a:pt x="561" y="864"/>
                  </a:lnTo>
                  <a:lnTo>
                    <a:pt x="747" y="864"/>
                  </a:lnTo>
                  <a:lnTo>
                    <a:pt x="747" y="883"/>
                  </a:lnTo>
                  <a:lnTo>
                    <a:pt x="805" y="883"/>
                  </a:lnTo>
                  <a:lnTo>
                    <a:pt x="805" y="902"/>
                  </a:lnTo>
                  <a:lnTo>
                    <a:pt x="889" y="902"/>
                  </a:lnTo>
                  <a:lnTo>
                    <a:pt x="889" y="922"/>
                  </a:lnTo>
                  <a:lnTo>
                    <a:pt x="915" y="922"/>
                  </a:lnTo>
                  <a:lnTo>
                    <a:pt x="1012" y="922"/>
                  </a:lnTo>
                  <a:lnTo>
                    <a:pt x="1012" y="948"/>
                  </a:lnTo>
                  <a:lnTo>
                    <a:pt x="1031" y="948"/>
                  </a:lnTo>
                  <a:lnTo>
                    <a:pt x="1031" y="967"/>
                  </a:lnTo>
                  <a:lnTo>
                    <a:pt x="1115" y="967"/>
                  </a:lnTo>
                  <a:lnTo>
                    <a:pt x="1231" y="967"/>
                  </a:lnTo>
                  <a:lnTo>
                    <a:pt x="1231" y="993"/>
                  </a:lnTo>
                  <a:lnTo>
                    <a:pt x="1778" y="993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Freeform 78">
              <a:extLst>
                <a:ext uri="{FF2B5EF4-FFF2-40B4-BE49-F238E27FC236}">
                  <a16:creationId xmlns:a16="http://schemas.microsoft.com/office/drawing/2014/main" id="{8944D033-33DF-4B28-8DE8-053C0F016F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7913" y="2063751"/>
              <a:ext cx="2822575" cy="1371600"/>
            </a:xfrm>
            <a:custGeom>
              <a:avLst/>
              <a:gdLst>
                <a:gd name="T0" fmla="*/ 13 w 1778"/>
                <a:gd name="T1" fmla="*/ 0 h 864"/>
                <a:gd name="T2" fmla="*/ 26 w 1778"/>
                <a:gd name="T3" fmla="*/ 19 h 864"/>
                <a:gd name="T4" fmla="*/ 32 w 1778"/>
                <a:gd name="T5" fmla="*/ 38 h 864"/>
                <a:gd name="T6" fmla="*/ 39 w 1778"/>
                <a:gd name="T7" fmla="*/ 64 h 864"/>
                <a:gd name="T8" fmla="*/ 45 w 1778"/>
                <a:gd name="T9" fmla="*/ 83 h 864"/>
                <a:gd name="T10" fmla="*/ 58 w 1778"/>
                <a:gd name="T11" fmla="*/ 103 h 864"/>
                <a:gd name="T12" fmla="*/ 64 w 1778"/>
                <a:gd name="T13" fmla="*/ 122 h 864"/>
                <a:gd name="T14" fmla="*/ 71 w 1778"/>
                <a:gd name="T15" fmla="*/ 148 h 864"/>
                <a:gd name="T16" fmla="*/ 77 w 1778"/>
                <a:gd name="T17" fmla="*/ 167 h 864"/>
                <a:gd name="T18" fmla="*/ 97 w 1778"/>
                <a:gd name="T19" fmla="*/ 187 h 864"/>
                <a:gd name="T20" fmla="*/ 110 w 1778"/>
                <a:gd name="T21" fmla="*/ 212 h 864"/>
                <a:gd name="T22" fmla="*/ 116 w 1778"/>
                <a:gd name="T23" fmla="*/ 232 h 864"/>
                <a:gd name="T24" fmla="*/ 122 w 1778"/>
                <a:gd name="T25" fmla="*/ 251 h 864"/>
                <a:gd name="T26" fmla="*/ 129 w 1778"/>
                <a:gd name="T27" fmla="*/ 270 h 864"/>
                <a:gd name="T28" fmla="*/ 135 w 1778"/>
                <a:gd name="T29" fmla="*/ 296 h 864"/>
                <a:gd name="T30" fmla="*/ 155 w 1778"/>
                <a:gd name="T31" fmla="*/ 316 h 864"/>
                <a:gd name="T32" fmla="*/ 180 w 1778"/>
                <a:gd name="T33" fmla="*/ 335 h 864"/>
                <a:gd name="T34" fmla="*/ 206 w 1778"/>
                <a:gd name="T35" fmla="*/ 361 h 864"/>
                <a:gd name="T36" fmla="*/ 219 w 1778"/>
                <a:gd name="T37" fmla="*/ 380 h 864"/>
                <a:gd name="T38" fmla="*/ 271 w 1778"/>
                <a:gd name="T39" fmla="*/ 399 h 864"/>
                <a:gd name="T40" fmla="*/ 271 w 1778"/>
                <a:gd name="T41" fmla="*/ 445 h 864"/>
                <a:gd name="T42" fmla="*/ 277 w 1778"/>
                <a:gd name="T43" fmla="*/ 470 h 864"/>
                <a:gd name="T44" fmla="*/ 290 w 1778"/>
                <a:gd name="T45" fmla="*/ 490 h 864"/>
                <a:gd name="T46" fmla="*/ 329 w 1778"/>
                <a:gd name="T47" fmla="*/ 515 h 864"/>
                <a:gd name="T48" fmla="*/ 354 w 1778"/>
                <a:gd name="T49" fmla="*/ 535 h 864"/>
                <a:gd name="T50" fmla="*/ 361 w 1778"/>
                <a:gd name="T51" fmla="*/ 561 h 864"/>
                <a:gd name="T52" fmla="*/ 393 w 1778"/>
                <a:gd name="T53" fmla="*/ 586 h 864"/>
                <a:gd name="T54" fmla="*/ 438 w 1778"/>
                <a:gd name="T55" fmla="*/ 586 h 864"/>
                <a:gd name="T56" fmla="*/ 445 w 1778"/>
                <a:gd name="T57" fmla="*/ 612 h 864"/>
                <a:gd name="T58" fmla="*/ 573 w 1778"/>
                <a:gd name="T59" fmla="*/ 638 h 864"/>
                <a:gd name="T60" fmla="*/ 793 w 1778"/>
                <a:gd name="T61" fmla="*/ 664 h 864"/>
                <a:gd name="T62" fmla="*/ 1070 w 1778"/>
                <a:gd name="T63" fmla="*/ 696 h 864"/>
                <a:gd name="T64" fmla="*/ 1153 w 1778"/>
                <a:gd name="T65" fmla="*/ 728 h 864"/>
                <a:gd name="T66" fmla="*/ 1250 w 1778"/>
                <a:gd name="T67" fmla="*/ 728 h 864"/>
                <a:gd name="T68" fmla="*/ 1327 w 1778"/>
                <a:gd name="T69" fmla="*/ 761 h 864"/>
                <a:gd name="T70" fmla="*/ 1566 w 1778"/>
                <a:gd name="T71" fmla="*/ 793 h 864"/>
                <a:gd name="T72" fmla="*/ 1759 w 1778"/>
                <a:gd name="T73" fmla="*/ 825 h 864"/>
                <a:gd name="T74" fmla="*/ 1778 w 1778"/>
                <a:gd name="T75" fmla="*/ 864 h 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1778" h="864">
                  <a:moveTo>
                    <a:pt x="0" y="0"/>
                  </a:moveTo>
                  <a:lnTo>
                    <a:pt x="13" y="0"/>
                  </a:lnTo>
                  <a:lnTo>
                    <a:pt x="13" y="19"/>
                  </a:lnTo>
                  <a:lnTo>
                    <a:pt x="26" y="19"/>
                  </a:lnTo>
                  <a:lnTo>
                    <a:pt x="32" y="19"/>
                  </a:lnTo>
                  <a:lnTo>
                    <a:pt x="32" y="38"/>
                  </a:lnTo>
                  <a:lnTo>
                    <a:pt x="39" y="38"/>
                  </a:lnTo>
                  <a:lnTo>
                    <a:pt x="39" y="64"/>
                  </a:lnTo>
                  <a:lnTo>
                    <a:pt x="39" y="83"/>
                  </a:lnTo>
                  <a:lnTo>
                    <a:pt x="45" y="83"/>
                  </a:lnTo>
                  <a:lnTo>
                    <a:pt x="58" y="83"/>
                  </a:lnTo>
                  <a:lnTo>
                    <a:pt x="58" y="103"/>
                  </a:lnTo>
                  <a:lnTo>
                    <a:pt x="64" y="103"/>
                  </a:lnTo>
                  <a:lnTo>
                    <a:pt x="64" y="122"/>
                  </a:lnTo>
                  <a:lnTo>
                    <a:pt x="71" y="122"/>
                  </a:lnTo>
                  <a:lnTo>
                    <a:pt x="71" y="148"/>
                  </a:lnTo>
                  <a:lnTo>
                    <a:pt x="77" y="148"/>
                  </a:lnTo>
                  <a:lnTo>
                    <a:pt x="77" y="167"/>
                  </a:lnTo>
                  <a:lnTo>
                    <a:pt x="97" y="167"/>
                  </a:lnTo>
                  <a:lnTo>
                    <a:pt x="97" y="187"/>
                  </a:lnTo>
                  <a:lnTo>
                    <a:pt x="110" y="187"/>
                  </a:lnTo>
                  <a:lnTo>
                    <a:pt x="110" y="212"/>
                  </a:lnTo>
                  <a:lnTo>
                    <a:pt x="116" y="212"/>
                  </a:lnTo>
                  <a:lnTo>
                    <a:pt x="116" y="232"/>
                  </a:lnTo>
                  <a:lnTo>
                    <a:pt x="122" y="232"/>
                  </a:lnTo>
                  <a:lnTo>
                    <a:pt x="122" y="251"/>
                  </a:lnTo>
                  <a:lnTo>
                    <a:pt x="129" y="251"/>
                  </a:lnTo>
                  <a:lnTo>
                    <a:pt x="129" y="270"/>
                  </a:lnTo>
                  <a:lnTo>
                    <a:pt x="135" y="270"/>
                  </a:lnTo>
                  <a:lnTo>
                    <a:pt x="135" y="296"/>
                  </a:lnTo>
                  <a:lnTo>
                    <a:pt x="155" y="296"/>
                  </a:lnTo>
                  <a:lnTo>
                    <a:pt x="155" y="316"/>
                  </a:lnTo>
                  <a:lnTo>
                    <a:pt x="180" y="316"/>
                  </a:lnTo>
                  <a:lnTo>
                    <a:pt x="180" y="335"/>
                  </a:lnTo>
                  <a:lnTo>
                    <a:pt x="206" y="335"/>
                  </a:lnTo>
                  <a:lnTo>
                    <a:pt x="206" y="361"/>
                  </a:lnTo>
                  <a:lnTo>
                    <a:pt x="219" y="361"/>
                  </a:lnTo>
                  <a:lnTo>
                    <a:pt x="219" y="380"/>
                  </a:lnTo>
                  <a:lnTo>
                    <a:pt x="219" y="399"/>
                  </a:lnTo>
                  <a:lnTo>
                    <a:pt x="271" y="399"/>
                  </a:lnTo>
                  <a:lnTo>
                    <a:pt x="271" y="425"/>
                  </a:lnTo>
                  <a:lnTo>
                    <a:pt x="271" y="445"/>
                  </a:lnTo>
                  <a:lnTo>
                    <a:pt x="277" y="445"/>
                  </a:lnTo>
                  <a:lnTo>
                    <a:pt x="277" y="470"/>
                  </a:lnTo>
                  <a:lnTo>
                    <a:pt x="290" y="470"/>
                  </a:lnTo>
                  <a:lnTo>
                    <a:pt x="290" y="490"/>
                  </a:lnTo>
                  <a:lnTo>
                    <a:pt x="329" y="490"/>
                  </a:lnTo>
                  <a:lnTo>
                    <a:pt x="329" y="515"/>
                  </a:lnTo>
                  <a:lnTo>
                    <a:pt x="354" y="515"/>
                  </a:lnTo>
                  <a:lnTo>
                    <a:pt x="354" y="535"/>
                  </a:lnTo>
                  <a:lnTo>
                    <a:pt x="361" y="535"/>
                  </a:lnTo>
                  <a:lnTo>
                    <a:pt x="361" y="561"/>
                  </a:lnTo>
                  <a:lnTo>
                    <a:pt x="393" y="561"/>
                  </a:lnTo>
                  <a:lnTo>
                    <a:pt x="393" y="586"/>
                  </a:lnTo>
                  <a:lnTo>
                    <a:pt x="400" y="586"/>
                  </a:lnTo>
                  <a:lnTo>
                    <a:pt x="438" y="586"/>
                  </a:lnTo>
                  <a:lnTo>
                    <a:pt x="438" y="612"/>
                  </a:lnTo>
                  <a:lnTo>
                    <a:pt x="445" y="612"/>
                  </a:lnTo>
                  <a:lnTo>
                    <a:pt x="445" y="638"/>
                  </a:lnTo>
                  <a:lnTo>
                    <a:pt x="573" y="638"/>
                  </a:lnTo>
                  <a:lnTo>
                    <a:pt x="573" y="664"/>
                  </a:lnTo>
                  <a:lnTo>
                    <a:pt x="793" y="664"/>
                  </a:lnTo>
                  <a:lnTo>
                    <a:pt x="1070" y="664"/>
                  </a:lnTo>
                  <a:lnTo>
                    <a:pt x="1070" y="696"/>
                  </a:lnTo>
                  <a:lnTo>
                    <a:pt x="1153" y="696"/>
                  </a:lnTo>
                  <a:lnTo>
                    <a:pt x="1153" y="728"/>
                  </a:lnTo>
                  <a:lnTo>
                    <a:pt x="1186" y="728"/>
                  </a:lnTo>
                  <a:lnTo>
                    <a:pt x="1250" y="728"/>
                  </a:lnTo>
                  <a:lnTo>
                    <a:pt x="1250" y="761"/>
                  </a:lnTo>
                  <a:lnTo>
                    <a:pt x="1327" y="761"/>
                  </a:lnTo>
                  <a:lnTo>
                    <a:pt x="1327" y="793"/>
                  </a:lnTo>
                  <a:lnTo>
                    <a:pt x="1566" y="793"/>
                  </a:lnTo>
                  <a:lnTo>
                    <a:pt x="1566" y="825"/>
                  </a:lnTo>
                  <a:lnTo>
                    <a:pt x="1759" y="825"/>
                  </a:lnTo>
                  <a:lnTo>
                    <a:pt x="1759" y="864"/>
                  </a:lnTo>
                  <a:lnTo>
                    <a:pt x="1778" y="864"/>
                  </a:lnTo>
                </a:path>
              </a:pathLst>
            </a:custGeom>
            <a:noFill/>
            <a:ln w="19050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Line 79">
              <a:extLst>
                <a:ext uri="{FF2B5EF4-FFF2-40B4-BE49-F238E27FC236}">
                  <a16:creationId xmlns:a16="http://schemas.microsoft.com/office/drawing/2014/main" id="{86F92F80-13BF-46AD-BBBE-247B61F62D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7913" y="2063751"/>
              <a:ext cx="0" cy="18415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Line 80">
              <a:extLst>
                <a:ext uri="{FF2B5EF4-FFF2-40B4-BE49-F238E27FC236}">
                  <a16:creationId xmlns:a16="http://schemas.microsoft.com/office/drawing/2014/main" id="{212B4975-6256-440A-8365-0A290D514E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87913" y="3905251"/>
              <a:ext cx="28225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Line 81">
              <a:extLst>
                <a:ext uri="{FF2B5EF4-FFF2-40B4-BE49-F238E27FC236}">
                  <a16:creationId xmlns:a16="http://schemas.microsoft.com/office/drawing/2014/main" id="{2D3B4016-FCD7-41C5-82F7-70C25BFBFC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7913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82">
              <a:extLst>
                <a:ext uri="{FF2B5EF4-FFF2-40B4-BE49-F238E27FC236}">
                  <a16:creationId xmlns:a16="http://schemas.microsoft.com/office/drawing/2014/main" id="{5189D567-2765-445A-BD1B-A6A09B59EB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6638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Line 83">
              <a:extLst>
                <a:ext uri="{FF2B5EF4-FFF2-40B4-BE49-F238E27FC236}">
                  <a16:creationId xmlns:a16="http://schemas.microsoft.com/office/drawing/2014/main" id="{8E428C3A-ECD6-4506-8E32-7AC2048995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73663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Line 84">
              <a:extLst>
                <a:ext uri="{FF2B5EF4-FFF2-40B4-BE49-F238E27FC236}">
                  <a16:creationId xmlns:a16="http://schemas.microsoft.com/office/drawing/2014/main" id="{081B96A6-3AE3-469C-A2A4-D2C755B92A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49888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85">
              <a:extLst>
                <a:ext uri="{FF2B5EF4-FFF2-40B4-BE49-F238E27FC236}">
                  <a16:creationId xmlns:a16="http://schemas.microsoft.com/office/drawing/2014/main" id="{9BAFA1BF-26C8-4637-B7EA-62668F21B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0200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Line 86">
              <a:extLst>
                <a:ext uri="{FF2B5EF4-FFF2-40B4-BE49-F238E27FC236}">
                  <a16:creationId xmlns:a16="http://schemas.microsoft.com/office/drawing/2014/main" id="{F6F58627-A8F0-44F9-A194-84480F610C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7225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Line 87">
              <a:extLst>
                <a:ext uri="{FF2B5EF4-FFF2-40B4-BE49-F238E27FC236}">
                  <a16:creationId xmlns:a16="http://schemas.microsoft.com/office/drawing/2014/main" id="{3713A5A0-BD22-449B-908C-043CA70674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13450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88">
              <a:extLst>
                <a:ext uri="{FF2B5EF4-FFF2-40B4-BE49-F238E27FC236}">
                  <a16:creationId xmlns:a16="http://schemas.microsoft.com/office/drawing/2014/main" id="{A559A252-370B-4F95-9B2A-911899D0F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2175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Line 89">
              <a:extLst>
                <a:ext uri="{FF2B5EF4-FFF2-40B4-BE49-F238E27FC236}">
                  <a16:creationId xmlns:a16="http://schemas.microsoft.com/office/drawing/2014/main" id="{87D47792-9491-4605-9362-7A462C22CF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200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Line 90">
              <a:extLst>
                <a:ext uri="{FF2B5EF4-FFF2-40B4-BE49-F238E27FC236}">
                  <a16:creationId xmlns:a16="http://schemas.microsoft.com/office/drawing/2014/main" id="{71551702-310D-47AA-AEFA-D1EE61A606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86538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91">
              <a:extLst>
                <a:ext uri="{FF2B5EF4-FFF2-40B4-BE49-F238E27FC236}">
                  <a16:creationId xmlns:a16="http://schemas.microsoft.com/office/drawing/2014/main" id="{DCE84E25-D0C6-4760-9A76-340E6E8D38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5263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Line 92">
              <a:extLst>
                <a:ext uri="{FF2B5EF4-FFF2-40B4-BE49-F238E27FC236}">
                  <a16:creationId xmlns:a16="http://schemas.microsoft.com/office/drawing/2014/main" id="{0C1B2D6B-285F-4180-A039-2E4F633F46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62763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Line 93">
              <a:extLst>
                <a:ext uri="{FF2B5EF4-FFF2-40B4-BE49-F238E27FC236}">
                  <a16:creationId xmlns:a16="http://schemas.microsoft.com/office/drawing/2014/main" id="{111D6159-44A2-4DF6-9513-E7FD7175C4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8513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94">
              <a:extLst>
                <a:ext uri="{FF2B5EF4-FFF2-40B4-BE49-F238E27FC236}">
                  <a16:creationId xmlns:a16="http://schemas.microsoft.com/office/drawing/2014/main" id="{20F2E67B-B023-43B6-8CDF-EAA91CAE78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07238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Line 95">
              <a:extLst>
                <a:ext uri="{FF2B5EF4-FFF2-40B4-BE49-F238E27FC236}">
                  <a16:creationId xmlns:a16="http://schemas.microsoft.com/office/drawing/2014/main" id="{1856E830-B468-4187-8653-5F5F21AE5B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4738" y="3905251"/>
              <a:ext cx="0" cy="317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Line 96">
              <a:extLst>
                <a:ext uri="{FF2B5EF4-FFF2-40B4-BE49-F238E27FC236}">
                  <a16:creationId xmlns:a16="http://schemas.microsoft.com/office/drawing/2014/main" id="{CE22BCB1-49EE-43CA-8702-A1DBA2A07F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10488" y="3905251"/>
              <a:ext cx="0" cy="619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97">
              <a:extLst>
                <a:ext uri="{FF2B5EF4-FFF2-40B4-BE49-F238E27FC236}">
                  <a16:creationId xmlns:a16="http://schemas.microsoft.com/office/drawing/2014/main" id="{1DAE36E9-9348-4275-B11C-CE7BA84AB7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0800" y="3976688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69" name="グループ化 2368">
            <a:extLst>
              <a:ext uri="{FF2B5EF4-FFF2-40B4-BE49-F238E27FC236}">
                <a16:creationId xmlns:a16="http://schemas.microsoft.com/office/drawing/2014/main" id="{752825A4-D8A5-4183-AE15-05FD57B91ACE}"/>
              </a:ext>
            </a:extLst>
          </p:cNvPr>
          <p:cNvGrpSpPr/>
          <p:nvPr/>
        </p:nvGrpSpPr>
        <p:grpSpPr>
          <a:xfrm>
            <a:off x="8683261" y="1061274"/>
            <a:ext cx="3137768" cy="2223631"/>
            <a:chOff x="8507413" y="1966913"/>
            <a:chExt cx="3137768" cy="2223631"/>
          </a:xfrm>
        </p:grpSpPr>
        <p:sp>
          <p:nvSpPr>
            <p:cNvPr id="363" name="Line 104">
              <a:extLst>
                <a:ext uri="{FF2B5EF4-FFF2-40B4-BE49-F238E27FC236}">
                  <a16:creationId xmlns:a16="http://schemas.microsoft.com/office/drawing/2014/main" id="{A314C4D4-3AB6-4345-8CCC-A9F4B2B88A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3903663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Rectangle 105">
              <a:extLst>
                <a:ext uri="{FF2B5EF4-FFF2-40B4-BE49-F238E27FC236}">
                  <a16:creationId xmlns:a16="http://schemas.microsoft.com/office/drawing/2014/main" id="{B6E2DFF8-1961-487C-AD56-9E94CB585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381158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Line 106">
              <a:extLst>
                <a:ext uri="{FF2B5EF4-FFF2-40B4-BE49-F238E27FC236}">
                  <a16:creationId xmlns:a16="http://schemas.microsoft.com/office/drawing/2014/main" id="{A3E5F0AD-686D-4864-9732-1289B91994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43950" y="3719513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Line 107">
              <a:extLst>
                <a:ext uri="{FF2B5EF4-FFF2-40B4-BE49-F238E27FC236}">
                  <a16:creationId xmlns:a16="http://schemas.microsoft.com/office/drawing/2014/main" id="{CB23C762-9549-4265-BF7C-EE8964A4FC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3535363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Rectangle 108">
              <a:extLst>
                <a:ext uri="{FF2B5EF4-FFF2-40B4-BE49-F238E27FC236}">
                  <a16:creationId xmlns:a16="http://schemas.microsoft.com/office/drawing/2014/main" id="{3A888A94-AA1D-4FC6-B33D-75BA86D5A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344328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Line 109">
              <a:extLst>
                <a:ext uri="{FF2B5EF4-FFF2-40B4-BE49-F238E27FC236}">
                  <a16:creationId xmlns:a16="http://schemas.microsoft.com/office/drawing/2014/main" id="{0705C4A0-531E-4497-851E-B528729097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43950" y="3351213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Line 110">
              <a:extLst>
                <a:ext uri="{FF2B5EF4-FFF2-40B4-BE49-F238E27FC236}">
                  <a16:creationId xmlns:a16="http://schemas.microsoft.com/office/drawing/2014/main" id="{B4CF1100-CAA9-4253-93F8-EA801C0FD4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3167063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111">
              <a:extLst>
                <a:ext uri="{FF2B5EF4-FFF2-40B4-BE49-F238E27FC236}">
                  <a16:creationId xmlns:a16="http://schemas.microsoft.com/office/drawing/2014/main" id="{2A5871AE-8761-4DEB-AA5A-5C3A02DB1C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307340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Line 112">
              <a:extLst>
                <a:ext uri="{FF2B5EF4-FFF2-40B4-BE49-F238E27FC236}">
                  <a16:creationId xmlns:a16="http://schemas.microsoft.com/office/drawing/2014/main" id="{CD8077DD-2777-41B0-A5E9-B9CB95C005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43950" y="2981325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Line 113">
              <a:extLst>
                <a:ext uri="{FF2B5EF4-FFF2-40B4-BE49-F238E27FC236}">
                  <a16:creationId xmlns:a16="http://schemas.microsoft.com/office/drawing/2014/main" id="{BD21FAF5-EAA8-49C1-9A47-033483F958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2797175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Rectangle 114">
              <a:extLst>
                <a:ext uri="{FF2B5EF4-FFF2-40B4-BE49-F238E27FC236}">
                  <a16:creationId xmlns:a16="http://schemas.microsoft.com/office/drawing/2014/main" id="{4D6B5889-FA72-4FCF-9AAD-DBEA121CD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270510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Line 115">
              <a:extLst>
                <a:ext uri="{FF2B5EF4-FFF2-40B4-BE49-F238E27FC236}">
                  <a16:creationId xmlns:a16="http://schemas.microsoft.com/office/drawing/2014/main" id="{F0B6B39D-3A51-4BDC-B4D8-AFB5862FB4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43950" y="2613025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Line 116">
              <a:extLst>
                <a:ext uri="{FF2B5EF4-FFF2-40B4-BE49-F238E27FC236}">
                  <a16:creationId xmlns:a16="http://schemas.microsoft.com/office/drawing/2014/main" id="{74517DCC-BD5B-43F7-814C-AAE5331364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2428875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Rectangle 117">
              <a:extLst>
                <a:ext uri="{FF2B5EF4-FFF2-40B4-BE49-F238E27FC236}">
                  <a16:creationId xmlns:a16="http://schemas.microsoft.com/office/drawing/2014/main" id="{916E32B7-2CE9-441B-A383-A2411BF9F1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233680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Line 118">
              <a:extLst>
                <a:ext uri="{FF2B5EF4-FFF2-40B4-BE49-F238E27FC236}">
                  <a16:creationId xmlns:a16="http://schemas.microsoft.com/office/drawing/2014/main" id="{16929BC3-3E88-4AA4-9CF2-461DCE3CFC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43950" y="2244725"/>
              <a:ext cx="301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Line 119">
              <a:extLst>
                <a:ext uri="{FF2B5EF4-FFF2-40B4-BE49-F238E27FC236}">
                  <a16:creationId xmlns:a16="http://schemas.microsoft.com/office/drawing/2014/main" id="{D7618843-3A47-4DAA-BEAE-2337F75456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12200" y="2060575"/>
              <a:ext cx="61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Rectangle 120">
              <a:extLst>
                <a:ext uri="{FF2B5EF4-FFF2-40B4-BE49-F238E27FC236}">
                  <a16:creationId xmlns:a16="http://schemas.microsoft.com/office/drawing/2014/main" id="{D5B07863-F7A1-44C9-900C-132C8AC66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7413" y="1966913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125">
              <a:extLst>
                <a:ext uri="{FF2B5EF4-FFF2-40B4-BE49-F238E27FC236}">
                  <a16:creationId xmlns:a16="http://schemas.microsoft.com/office/drawing/2014/main" id="{BC76F8CB-13CF-481B-A282-46C857209DD0}"/>
                </a:ext>
              </a:extLst>
            </p:cNvPr>
            <p:cNvSpPr>
              <a:spLocks/>
            </p:cNvSpPr>
            <p:nvPr/>
          </p:nvSpPr>
          <p:spPr bwMode="auto">
            <a:xfrm>
              <a:off x="8774113" y="2060575"/>
              <a:ext cx="2820988" cy="1330325"/>
            </a:xfrm>
            <a:custGeom>
              <a:avLst/>
              <a:gdLst>
                <a:gd name="T0" fmla="*/ 13 w 1777"/>
                <a:gd name="T1" fmla="*/ 13 h 838"/>
                <a:gd name="T2" fmla="*/ 32 w 1777"/>
                <a:gd name="T3" fmla="*/ 19 h 838"/>
                <a:gd name="T4" fmla="*/ 39 w 1777"/>
                <a:gd name="T5" fmla="*/ 38 h 838"/>
                <a:gd name="T6" fmla="*/ 45 w 1777"/>
                <a:gd name="T7" fmla="*/ 58 h 838"/>
                <a:gd name="T8" fmla="*/ 58 w 1777"/>
                <a:gd name="T9" fmla="*/ 90 h 838"/>
                <a:gd name="T10" fmla="*/ 71 w 1777"/>
                <a:gd name="T11" fmla="*/ 103 h 838"/>
                <a:gd name="T12" fmla="*/ 77 w 1777"/>
                <a:gd name="T13" fmla="*/ 122 h 838"/>
                <a:gd name="T14" fmla="*/ 84 w 1777"/>
                <a:gd name="T15" fmla="*/ 142 h 838"/>
                <a:gd name="T16" fmla="*/ 90 w 1777"/>
                <a:gd name="T17" fmla="*/ 161 h 838"/>
                <a:gd name="T18" fmla="*/ 96 w 1777"/>
                <a:gd name="T19" fmla="*/ 180 h 838"/>
                <a:gd name="T20" fmla="*/ 103 w 1777"/>
                <a:gd name="T21" fmla="*/ 200 h 838"/>
                <a:gd name="T22" fmla="*/ 109 w 1777"/>
                <a:gd name="T23" fmla="*/ 219 h 838"/>
                <a:gd name="T24" fmla="*/ 116 w 1777"/>
                <a:gd name="T25" fmla="*/ 238 h 838"/>
                <a:gd name="T26" fmla="*/ 122 w 1777"/>
                <a:gd name="T27" fmla="*/ 258 h 838"/>
                <a:gd name="T28" fmla="*/ 129 w 1777"/>
                <a:gd name="T29" fmla="*/ 277 h 838"/>
                <a:gd name="T30" fmla="*/ 148 w 1777"/>
                <a:gd name="T31" fmla="*/ 290 h 838"/>
                <a:gd name="T32" fmla="*/ 154 w 1777"/>
                <a:gd name="T33" fmla="*/ 322 h 838"/>
                <a:gd name="T34" fmla="*/ 180 w 1777"/>
                <a:gd name="T35" fmla="*/ 329 h 838"/>
                <a:gd name="T36" fmla="*/ 187 w 1777"/>
                <a:gd name="T37" fmla="*/ 348 h 838"/>
                <a:gd name="T38" fmla="*/ 206 w 1777"/>
                <a:gd name="T39" fmla="*/ 361 h 838"/>
                <a:gd name="T40" fmla="*/ 219 w 1777"/>
                <a:gd name="T41" fmla="*/ 380 h 838"/>
                <a:gd name="T42" fmla="*/ 257 w 1777"/>
                <a:gd name="T43" fmla="*/ 406 h 838"/>
                <a:gd name="T44" fmla="*/ 270 w 1777"/>
                <a:gd name="T45" fmla="*/ 425 h 838"/>
                <a:gd name="T46" fmla="*/ 277 w 1777"/>
                <a:gd name="T47" fmla="*/ 445 h 838"/>
                <a:gd name="T48" fmla="*/ 290 w 1777"/>
                <a:gd name="T49" fmla="*/ 477 h 838"/>
                <a:gd name="T50" fmla="*/ 309 w 1777"/>
                <a:gd name="T51" fmla="*/ 490 h 838"/>
                <a:gd name="T52" fmla="*/ 328 w 1777"/>
                <a:gd name="T53" fmla="*/ 509 h 838"/>
                <a:gd name="T54" fmla="*/ 354 w 1777"/>
                <a:gd name="T55" fmla="*/ 516 h 838"/>
                <a:gd name="T56" fmla="*/ 361 w 1777"/>
                <a:gd name="T57" fmla="*/ 542 h 838"/>
                <a:gd name="T58" fmla="*/ 399 w 1777"/>
                <a:gd name="T59" fmla="*/ 555 h 838"/>
                <a:gd name="T60" fmla="*/ 438 w 1777"/>
                <a:gd name="T61" fmla="*/ 561 h 838"/>
                <a:gd name="T62" fmla="*/ 444 w 1777"/>
                <a:gd name="T63" fmla="*/ 587 h 838"/>
                <a:gd name="T64" fmla="*/ 579 w 1777"/>
                <a:gd name="T65" fmla="*/ 600 h 838"/>
                <a:gd name="T66" fmla="*/ 773 w 1777"/>
                <a:gd name="T67" fmla="*/ 626 h 838"/>
                <a:gd name="T68" fmla="*/ 792 w 1777"/>
                <a:gd name="T69" fmla="*/ 638 h 838"/>
                <a:gd name="T70" fmla="*/ 934 w 1777"/>
                <a:gd name="T71" fmla="*/ 658 h 838"/>
                <a:gd name="T72" fmla="*/ 998 w 1777"/>
                <a:gd name="T73" fmla="*/ 671 h 838"/>
                <a:gd name="T74" fmla="*/ 1069 w 1777"/>
                <a:gd name="T75" fmla="*/ 697 h 838"/>
                <a:gd name="T76" fmla="*/ 1185 w 1777"/>
                <a:gd name="T77" fmla="*/ 709 h 838"/>
                <a:gd name="T78" fmla="*/ 1249 w 1777"/>
                <a:gd name="T79" fmla="*/ 735 h 838"/>
                <a:gd name="T80" fmla="*/ 1327 w 1777"/>
                <a:gd name="T81" fmla="*/ 755 h 838"/>
                <a:gd name="T82" fmla="*/ 1442 w 1777"/>
                <a:gd name="T83" fmla="*/ 767 h 838"/>
                <a:gd name="T84" fmla="*/ 1565 w 1777"/>
                <a:gd name="T85" fmla="*/ 793 h 838"/>
                <a:gd name="T86" fmla="*/ 1655 w 1777"/>
                <a:gd name="T87" fmla="*/ 806 h 838"/>
                <a:gd name="T88" fmla="*/ 1732 w 1777"/>
                <a:gd name="T89" fmla="*/ 819 h 838"/>
                <a:gd name="T90" fmla="*/ 1777 w 1777"/>
                <a:gd name="T91" fmla="*/ 838 h 8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1777" h="838">
                  <a:moveTo>
                    <a:pt x="0" y="0"/>
                  </a:moveTo>
                  <a:lnTo>
                    <a:pt x="13" y="0"/>
                  </a:lnTo>
                  <a:lnTo>
                    <a:pt x="13" y="13"/>
                  </a:lnTo>
                  <a:lnTo>
                    <a:pt x="26" y="13"/>
                  </a:lnTo>
                  <a:lnTo>
                    <a:pt x="26" y="19"/>
                  </a:lnTo>
                  <a:lnTo>
                    <a:pt x="32" y="19"/>
                  </a:lnTo>
                  <a:lnTo>
                    <a:pt x="32" y="32"/>
                  </a:lnTo>
                  <a:lnTo>
                    <a:pt x="39" y="32"/>
                  </a:lnTo>
                  <a:lnTo>
                    <a:pt x="39" y="38"/>
                  </a:lnTo>
                  <a:lnTo>
                    <a:pt x="39" y="51"/>
                  </a:lnTo>
                  <a:lnTo>
                    <a:pt x="45" y="51"/>
                  </a:lnTo>
                  <a:lnTo>
                    <a:pt x="45" y="58"/>
                  </a:lnTo>
                  <a:lnTo>
                    <a:pt x="58" y="58"/>
                  </a:lnTo>
                  <a:lnTo>
                    <a:pt x="58" y="71"/>
                  </a:lnTo>
                  <a:lnTo>
                    <a:pt x="58" y="90"/>
                  </a:lnTo>
                  <a:lnTo>
                    <a:pt x="64" y="90"/>
                  </a:lnTo>
                  <a:lnTo>
                    <a:pt x="64" y="103"/>
                  </a:lnTo>
                  <a:lnTo>
                    <a:pt x="71" y="103"/>
                  </a:lnTo>
                  <a:lnTo>
                    <a:pt x="71" y="109"/>
                  </a:lnTo>
                  <a:lnTo>
                    <a:pt x="77" y="109"/>
                  </a:lnTo>
                  <a:lnTo>
                    <a:pt x="77" y="122"/>
                  </a:lnTo>
                  <a:lnTo>
                    <a:pt x="84" y="122"/>
                  </a:lnTo>
                  <a:lnTo>
                    <a:pt x="84" y="129"/>
                  </a:lnTo>
                  <a:lnTo>
                    <a:pt x="84" y="142"/>
                  </a:lnTo>
                  <a:lnTo>
                    <a:pt x="90" y="142"/>
                  </a:lnTo>
                  <a:lnTo>
                    <a:pt x="90" y="148"/>
                  </a:lnTo>
                  <a:lnTo>
                    <a:pt x="90" y="161"/>
                  </a:lnTo>
                  <a:lnTo>
                    <a:pt x="90" y="167"/>
                  </a:lnTo>
                  <a:lnTo>
                    <a:pt x="90" y="180"/>
                  </a:lnTo>
                  <a:lnTo>
                    <a:pt x="96" y="180"/>
                  </a:lnTo>
                  <a:lnTo>
                    <a:pt x="96" y="187"/>
                  </a:lnTo>
                  <a:lnTo>
                    <a:pt x="96" y="200"/>
                  </a:lnTo>
                  <a:lnTo>
                    <a:pt x="103" y="200"/>
                  </a:lnTo>
                  <a:lnTo>
                    <a:pt x="103" y="213"/>
                  </a:lnTo>
                  <a:lnTo>
                    <a:pt x="109" y="213"/>
                  </a:lnTo>
                  <a:lnTo>
                    <a:pt x="109" y="219"/>
                  </a:lnTo>
                  <a:lnTo>
                    <a:pt x="109" y="232"/>
                  </a:lnTo>
                  <a:lnTo>
                    <a:pt x="109" y="238"/>
                  </a:lnTo>
                  <a:lnTo>
                    <a:pt x="116" y="238"/>
                  </a:lnTo>
                  <a:lnTo>
                    <a:pt x="116" y="251"/>
                  </a:lnTo>
                  <a:lnTo>
                    <a:pt x="116" y="258"/>
                  </a:lnTo>
                  <a:lnTo>
                    <a:pt x="122" y="258"/>
                  </a:lnTo>
                  <a:lnTo>
                    <a:pt x="122" y="271"/>
                  </a:lnTo>
                  <a:lnTo>
                    <a:pt x="129" y="271"/>
                  </a:lnTo>
                  <a:lnTo>
                    <a:pt x="129" y="277"/>
                  </a:lnTo>
                  <a:lnTo>
                    <a:pt x="135" y="277"/>
                  </a:lnTo>
                  <a:lnTo>
                    <a:pt x="135" y="290"/>
                  </a:lnTo>
                  <a:lnTo>
                    <a:pt x="148" y="290"/>
                  </a:lnTo>
                  <a:lnTo>
                    <a:pt x="148" y="309"/>
                  </a:lnTo>
                  <a:lnTo>
                    <a:pt x="154" y="309"/>
                  </a:lnTo>
                  <a:lnTo>
                    <a:pt x="154" y="322"/>
                  </a:lnTo>
                  <a:lnTo>
                    <a:pt x="154" y="329"/>
                  </a:lnTo>
                  <a:lnTo>
                    <a:pt x="174" y="329"/>
                  </a:lnTo>
                  <a:lnTo>
                    <a:pt x="180" y="329"/>
                  </a:lnTo>
                  <a:lnTo>
                    <a:pt x="180" y="342"/>
                  </a:lnTo>
                  <a:lnTo>
                    <a:pt x="187" y="342"/>
                  </a:lnTo>
                  <a:lnTo>
                    <a:pt x="187" y="348"/>
                  </a:lnTo>
                  <a:lnTo>
                    <a:pt x="193" y="348"/>
                  </a:lnTo>
                  <a:lnTo>
                    <a:pt x="206" y="348"/>
                  </a:lnTo>
                  <a:lnTo>
                    <a:pt x="206" y="361"/>
                  </a:lnTo>
                  <a:lnTo>
                    <a:pt x="206" y="374"/>
                  </a:lnTo>
                  <a:lnTo>
                    <a:pt x="206" y="380"/>
                  </a:lnTo>
                  <a:lnTo>
                    <a:pt x="219" y="380"/>
                  </a:lnTo>
                  <a:lnTo>
                    <a:pt x="219" y="393"/>
                  </a:lnTo>
                  <a:lnTo>
                    <a:pt x="219" y="406"/>
                  </a:lnTo>
                  <a:lnTo>
                    <a:pt x="257" y="406"/>
                  </a:lnTo>
                  <a:lnTo>
                    <a:pt x="257" y="413"/>
                  </a:lnTo>
                  <a:lnTo>
                    <a:pt x="270" y="413"/>
                  </a:lnTo>
                  <a:lnTo>
                    <a:pt x="270" y="425"/>
                  </a:lnTo>
                  <a:lnTo>
                    <a:pt x="270" y="432"/>
                  </a:lnTo>
                  <a:lnTo>
                    <a:pt x="270" y="445"/>
                  </a:lnTo>
                  <a:lnTo>
                    <a:pt x="277" y="445"/>
                  </a:lnTo>
                  <a:lnTo>
                    <a:pt x="277" y="458"/>
                  </a:lnTo>
                  <a:lnTo>
                    <a:pt x="290" y="458"/>
                  </a:lnTo>
                  <a:lnTo>
                    <a:pt x="290" y="477"/>
                  </a:lnTo>
                  <a:lnTo>
                    <a:pt x="296" y="477"/>
                  </a:lnTo>
                  <a:lnTo>
                    <a:pt x="296" y="490"/>
                  </a:lnTo>
                  <a:lnTo>
                    <a:pt x="309" y="490"/>
                  </a:lnTo>
                  <a:lnTo>
                    <a:pt x="309" y="496"/>
                  </a:lnTo>
                  <a:lnTo>
                    <a:pt x="328" y="496"/>
                  </a:lnTo>
                  <a:lnTo>
                    <a:pt x="328" y="509"/>
                  </a:lnTo>
                  <a:lnTo>
                    <a:pt x="341" y="509"/>
                  </a:lnTo>
                  <a:lnTo>
                    <a:pt x="341" y="516"/>
                  </a:lnTo>
                  <a:lnTo>
                    <a:pt x="354" y="516"/>
                  </a:lnTo>
                  <a:lnTo>
                    <a:pt x="354" y="529"/>
                  </a:lnTo>
                  <a:lnTo>
                    <a:pt x="361" y="529"/>
                  </a:lnTo>
                  <a:lnTo>
                    <a:pt x="361" y="542"/>
                  </a:lnTo>
                  <a:lnTo>
                    <a:pt x="393" y="542"/>
                  </a:lnTo>
                  <a:lnTo>
                    <a:pt x="393" y="555"/>
                  </a:lnTo>
                  <a:lnTo>
                    <a:pt x="399" y="555"/>
                  </a:lnTo>
                  <a:lnTo>
                    <a:pt x="399" y="561"/>
                  </a:lnTo>
                  <a:lnTo>
                    <a:pt x="425" y="561"/>
                  </a:lnTo>
                  <a:lnTo>
                    <a:pt x="438" y="561"/>
                  </a:lnTo>
                  <a:lnTo>
                    <a:pt x="438" y="574"/>
                  </a:lnTo>
                  <a:lnTo>
                    <a:pt x="444" y="574"/>
                  </a:lnTo>
                  <a:lnTo>
                    <a:pt x="444" y="587"/>
                  </a:lnTo>
                  <a:lnTo>
                    <a:pt x="573" y="587"/>
                  </a:lnTo>
                  <a:lnTo>
                    <a:pt x="573" y="600"/>
                  </a:lnTo>
                  <a:lnTo>
                    <a:pt x="579" y="600"/>
                  </a:lnTo>
                  <a:lnTo>
                    <a:pt x="579" y="613"/>
                  </a:lnTo>
                  <a:lnTo>
                    <a:pt x="773" y="613"/>
                  </a:lnTo>
                  <a:lnTo>
                    <a:pt x="773" y="626"/>
                  </a:lnTo>
                  <a:lnTo>
                    <a:pt x="786" y="626"/>
                  </a:lnTo>
                  <a:lnTo>
                    <a:pt x="786" y="638"/>
                  </a:lnTo>
                  <a:lnTo>
                    <a:pt x="792" y="638"/>
                  </a:lnTo>
                  <a:lnTo>
                    <a:pt x="914" y="638"/>
                  </a:lnTo>
                  <a:lnTo>
                    <a:pt x="914" y="658"/>
                  </a:lnTo>
                  <a:lnTo>
                    <a:pt x="934" y="658"/>
                  </a:lnTo>
                  <a:lnTo>
                    <a:pt x="934" y="671"/>
                  </a:lnTo>
                  <a:lnTo>
                    <a:pt x="985" y="671"/>
                  </a:lnTo>
                  <a:lnTo>
                    <a:pt x="998" y="671"/>
                  </a:lnTo>
                  <a:lnTo>
                    <a:pt x="998" y="684"/>
                  </a:lnTo>
                  <a:lnTo>
                    <a:pt x="1069" y="684"/>
                  </a:lnTo>
                  <a:lnTo>
                    <a:pt x="1069" y="697"/>
                  </a:lnTo>
                  <a:lnTo>
                    <a:pt x="1153" y="697"/>
                  </a:lnTo>
                  <a:lnTo>
                    <a:pt x="1153" y="709"/>
                  </a:lnTo>
                  <a:lnTo>
                    <a:pt x="1185" y="709"/>
                  </a:lnTo>
                  <a:lnTo>
                    <a:pt x="1249" y="709"/>
                  </a:lnTo>
                  <a:lnTo>
                    <a:pt x="1249" y="722"/>
                  </a:lnTo>
                  <a:lnTo>
                    <a:pt x="1249" y="735"/>
                  </a:lnTo>
                  <a:lnTo>
                    <a:pt x="1301" y="735"/>
                  </a:lnTo>
                  <a:lnTo>
                    <a:pt x="1327" y="735"/>
                  </a:lnTo>
                  <a:lnTo>
                    <a:pt x="1327" y="755"/>
                  </a:lnTo>
                  <a:lnTo>
                    <a:pt x="1378" y="755"/>
                  </a:lnTo>
                  <a:lnTo>
                    <a:pt x="1378" y="767"/>
                  </a:lnTo>
                  <a:lnTo>
                    <a:pt x="1442" y="767"/>
                  </a:lnTo>
                  <a:lnTo>
                    <a:pt x="1442" y="780"/>
                  </a:lnTo>
                  <a:lnTo>
                    <a:pt x="1565" y="780"/>
                  </a:lnTo>
                  <a:lnTo>
                    <a:pt x="1565" y="793"/>
                  </a:lnTo>
                  <a:lnTo>
                    <a:pt x="1591" y="793"/>
                  </a:lnTo>
                  <a:lnTo>
                    <a:pt x="1655" y="793"/>
                  </a:lnTo>
                  <a:lnTo>
                    <a:pt x="1655" y="806"/>
                  </a:lnTo>
                  <a:lnTo>
                    <a:pt x="1681" y="806"/>
                  </a:lnTo>
                  <a:lnTo>
                    <a:pt x="1681" y="819"/>
                  </a:lnTo>
                  <a:lnTo>
                    <a:pt x="1732" y="819"/>
                  </a:lnTo>
                  <a:lnTo>
                    <a:pt x="1758" y="819"/>
                  </a:lnTo>
                  <a:lnTo>
                    <a:pt x="1758" y="838"/>
                  </a:lnTo>
                  <a:lnTo>
                    <a:pt x="1777" y="838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Freeform 126">
              <a:extLst>
                <a:ext uri="{FF2B5EF4-FFF2-40B4-BE49-F238E27FC236}">
                  <a16:creationId xmlns:a16="http://schemas.microsoft.com/office/drawing/2014/main" id="{F9F73487-AD74-4EF5-8412-96A3F3BE1CE2}"/>
                </a:ext>
              </a:extLst>
            </p:cNvPr>
            <p:cNvSpPr>
              <a:spLocks/>
            </p:cNvSpPr>
            <p:nvPr/>
          </p:nvSpPr>
          <p:spPr bwMode="auto">
            <a:xfrm>
              <a:off x="8774113" y="2060575"/>
              <a:ext cx="2820988" cy="1576387"/>
            </a:xfrm>
            <a:custGeom>
              <a:avLst/>
              <a:gdLst>
                <a:gd name="T0" fmla="*/ 0 w 1777"/>
                <a:gd name="T1" fmla="*/ 0 h 993"/>
                <a:gd name="T2" fmla="*/ 26 w 1777"/>
                <a:gd name="T3" fmla="*/ 19 h 993"/>
                <a:gd name="T4" fmla="*/ 32 w 1777"/>
                <a:gd name="T5" fmla="*/ 38 h 993"/>
                <a:gd name="T6" fmla="*/ 39 w 1777"/>
                <a:gd name="T7" fmla="*/ 58 h 993"/>
                <a:gd name="T8" fmla="*/ 45 w 1777"/>
                <a:gd name="T9" fmla="*/ 71 h 993"/>
                <a:gd name="T10" fmla="*/ 64 w 1777"/>
                <a:gd name="T11" fmla="*/ 90 h 993"/>
                <a:gd name="T12" fmla="*/ 64 w 1777"/>
                <a:gd name="T13" fmla="*/ 129 h 993"/>
                <a:gd name="T14" fmla="*/ 71 w 1777"/>
                <a:gd name="T15" fmla="*/ 167 h 993"/>
                <a:gd name="T16" fmla="*/ 77 w 1777"/>
                <a:gd name="T17" fmla="*/ 187 h 993"/>
                <a:gd name="T18" fmla="*/ 90 w 1777"/>
                <a:gd name="T19" fmla="*/ 238 h 993"/>
                <a:gd name="T20" fmla="*/ 103 w 1777"/>
                <a:gd name="T21" fmla="*/ 258 h 993"/>
                <a:gd name="T22" fmla="*/ 109 w 1777"/>
                <a:gd name="T23" fmla="*/ 277 h 993"/>
                <a:gd name="T24" fmla="*/ 129 w 1777"/>
                <a:gd name="T25" fmla="*/ 316 h 993"/>
                <a:gd name="T26" fmla="*/ 135 w 1777"/>
                <a:gd name="T27" fmla="*/ 329 h 993"/>
                <a:gd name="T28" fmla="*/ 148 w 1777"/>
                <a:gd name="T29" fmla="*/ 348 h 993"/>
                <a:gd name="T30" fmla="*/ 154 w 1777"/>
                <a:gd name="T31" fmla="*/ 367 h 993"/>
                <a:gd name="T32" fmla="*/ 161 w 1777"/>
                <a:gd name="T33" fmla="*/ 387 h 993"/>
                <a:gd name="T34" fmla="*/ 161 w 1777"/>
                <a:gd name="T35" fmla="*/ 425 h 993"/>
                <a:gd name="T36" fmla="*/ 174 w 1777"/>
                <a:gd name="T37" fmla="*/ 445 h 993"/>
                <a:gd name="T38" fmla="*/ 180 w 1777"/>
                <a:gd name="T39" fmla="*/ 458 h 993"/>
                <a:gd name="T40" fmla="*/ 193 w 1777"/>
                <a:gd name="T41" fmla="*/ 458 h 993"/>
                <a:gd name="T42" fmla="*/ 206 w 1777"/>
                <a:gd name="T43" fmla="*/ 477 h 993"/>
                <a:gd name="T44" fmla="*/ 212 w 1777"/>
                <a:gd name="T45" fmla="*/ 496 h 993"/>
                <a:gd name="T46" fmla="*/ 212 w 1777"/>
                <a:gd name="T47" fmla="*/ 535 h 993"/>
                <a:gd name="T48" fmla="*/ 219 w 1777"/>
                <a:gd name="T49" fmla="*/ 555 h 993"/>
                <a:gd name="T50" fmla="*/ 238 w 1777"/>
                <a:gd name="T51" fmla="*/ 574 h 993"/>
                <a:gd name="T52" fmla="*/ 245 w 1777"/>
                <a:gd name="T53" fmla="*/ 593 h 993"/>
                <a:gd name="T54" fmla="*/ 277 w 1777"/>
                <a:gd name="T55" fmla="*/ 613 h 993"/>
                <a:gd name="T56" fmla="*/ 277 w 1777"/>
                <a:gd name="T57" fmla="*/ 651 h 993"/>
                <a:gd name="T58" fmla="*/ 290 w 1777"/>
                <a:gd name="T59" fmla="*/ 671 h 993"/>
                <a:gd name="T60" fmla="*/ 296 w 1777"/>
                <a:gd name="T61" fmla="*/ 690 h 993"/>
                <a:gd name="T62" fmla="*/ 303 w 1777"/>
                <a:gd name="T63" fmla="*/ 709 h 993"/>
                <a:gd name="T64" fmla="*/ 354 w 1777"/>
                <a:gd name="T65" fmla="*/ 709 h 993"/>
                <a:gd name="T66" fmla="*/ 361 w 1777"/>
                <a:gd name="T67" fmla="*/ 729 h 993"/>
                <a:gd name="T68" fmla="*/ 418 w 1777"/>
                <a:gd name="T69" fmla="*/ 748 h 993"/>
                <a:gd name="T70" fmla="*/ 438 w 1777"/>
                <a:gd name="T71" fmla="*/ 767 h 993"/>
                <a:gd name="T72" fmla="*/ 470 w 1777"/>
                <a:gd name="T73" fmla="*/ 787 h 993"/>
                <a:gd name="T74" fmla="*/ 476 w 1777"/>
                <a:gd name="T75" fmla="*/ 806 h 993"/>
                <a:gd name="T76" fmla="*/ 489 w 1777"/>
                <a:gd name="T77" fmla="*/ 826 h 993"/>
                <a:gd name="T78" fmla="*/ 560 w 1777"/>
                <a:gd name="T79" fmla="*/ 845 h 993"/>
                <a:gd name="T80" fmla="*/ 747 w 1777"/>
                <a:gd name="T81" fmla="*/ 864 h 993"/>
                <a:gd name="T82" fmla="*/ 805 w 1777"/>
                <a:gd name="T83" fmla="*/ 884 h 993"/>
                <a:gd name="T84" fmla="*/ 889 w 1777"/>
                <a:gd name="T85" fmla="*/ 903 h 993"/>
                <a:gd name="T86" fmla="*/ 914 w 1777"/>
                <a:gd name="T87" fmla="*/ 922 h 993"/>
                <a:gd name="T88" fmla="*/ 1011 w 1777"/>
                <a:gd name="T89" fmla="*/ 948 h 993"/>
                <a:gd name="T90" fmla="*/ 1030 w 1777"/>
                <a:gd name="T91" fmla="*/ 968 h 993"/>
                <a:gd name="T92" fmla="*/ 1230 w 1777"/>
                <a:gd name="T93" fmla="*/ 968 h 993"/>
                <a:gd name="T94" fmla="*/ 1777 w 1777"/>
                <a:gd name="T95" fmla="*/ 993 h 9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777" h="993">
                  <a:moveTo>
                    <a:pt x="0" y="0"/>
                  </a:moveTo>
                  <a:lnTo>
                    <a:pt x="0" y="0"/>
                  </a:lnTo>
                  <a:lnTo>
                    <a:pt x="0" y="19"/>
                  </a:lnTo>
                  <a:lnTo>
                    <a:pt x="26" y="19"/>
                  </a:lnTo>
                  <a:lnTo>
                    <a:pt x="26" y="38"/>
                  </a:lnTo>
                  <a:lnTo>
                    <a:pt x="32" y="38"/>
                  </a:lnTo>
                  <a:lnTo>
                    <a:pt x="32" y="58"/>
                  </a:lnTo>
                  <a:lnTo>
                    <a:pt x="39" y="58"/>
                  </a:lnTo>
                  <a:lnTo>
                    <a:pt x="39" y="71"/>
                  </a:lnTo>
                  <a:lnTo>
                    <a:pt x="45" y="71"/>
                  </a:lnTo>
                  <a:lnTo>
                    <a:pt x="45" y="90"/>
                  </a:lnTo>
                  <a:lnTo>
                    <a:pt x="64" y="90"/>
                  </a:lnTo>
                  <a:lnTo>
                    <a:pt x="64" y="109"/>
                  </a:lnTo>
                  <a:lnTo>
                    <a:pt x="64" y="129"/>
                  </a:lnTo>
                  <a:lnTo>
                    <a:pt x="71" y="129"/>
                  </a:lnTo>
                  <a:lnTo>
                    <a:pt x="71" y="167"/>
                  </a:lnTo>
                  <a:lnTo>
                    <a:pt x="77" y="167"/>
                  </a:lnTo>
                  <a:lnTo>
                    <a:pt x="77" y="187"/>
                  </a:lnTo>
                  <a:lnTo>
                    <a:pt x="90" y="187"/>
                  </a:lnTo>
                  <a:lnTo>
                    <a:pt x="90" y="238"/>
                  </a:lnTo>
                  <a:lnTo>
                    <a:pt x="103" y="238"/>
                  </a:lnTo>
                  <a:lnTo>
                    <a:pt x="103" y="258"/>
                  </a:lnTo>
                  <a:lnTo>
                    <a:pt x="103" y="277"/>
                  </a:lnTo>
                  <a:lnTo>
                    <a:pt x="109" y="277"/>
                  </a:lnTo>
                  <a:lnTo>
                    <a:pt x="109" y="316"/>
                  </a:lnTo>
                  <a:lnTo>
                    <a:pt x="129" y="316"/>
                  </a:lnTo>
                  <a:lnTo>
                    <a:pt x="129" y="329"/>
                  </a:lnTo>
                  <a:lnTo>
                    <a:pt x="135" y="329"/>
                  </a:lnTo>
                  <a:lnTo>
                    <a:pt x="135" y="348"/>
                  </a:lnTo>
                  <a:lnTo>
                    <a:pt x="148" y="348"/>
                  </a:lnTo>
                  <a:lnTo>
                    <a:pt x="148" y="367"/>
                  </a:lnTo>
                  <a:lnTo>
                    <a:pt x="154" y="367"/>
                  </a:lnTo>
                  <a:lnTo>
                    <a:pt x="154" y="387"/>
                  </a:lnTo>
                  <a:lnTo>
                    <a:pt x="161" y="387"/>
                  </a:lnTo>
                  <a:lnTo>
                    <a:pt x="161" y="406"/>
                  </a:lnTo>
                  <a:lnTo>
                    <a:pt x="161" y="425"/>
                  </a:lnTo>
                  <a:lnTo>
                    <a:pt x="174" y="425"/>
                  </a:lnTo>
                  <a:lnTo>
                    <a:pt x="174" y="445"/>
                  </a:lnTo>
                  <a:lnTo>
                    <a:pt x="180" y="445"/>
                  </a:lnTo>
                  <a:lnTo>
                    <a:pt x="180" y="458"/>
                  </a:lnTo>
                  <a:lnTo>
                    <a:pt x="187" y="458"/>
                  </a:lnTo>
                  <a:lnTo>
                    <a:pt x="193" y="458"/>
                  </a:lnTo>
                  <a:lnTo>
                    <a:pt x="193" y="477"/>
                  </a:lnTo>
                  <a:lnTo>
                    <a:pt x="206" y="477"/>
                  </a:lnTo>
                  <a:lnTo>
                    <a:pt x="206" y="496"/>
                  </a:lnTo>
                  <a:lnTo>
                    <a:pt x="212" y="496"/>
                  </a:lnTo>
                  <a:lnTo>
                    <a:pt x="212" y="516"/>
                  </a:lnTo>
                  <a:lnTo>
                    <a:pt x="212" y="535"/>
                  </a:lnTo>
                  <a:lnTo>
                    <a:pt x="219" y="535"/>
                  </a:lnTo>
                  <a:lnTo>
                    <a:pt x="219" y="555"/>
                  </a:lnTo>
                  <a:lnTo>
                    <a:pt x="238" y="555"/>
                  </a:lnTo>
                  <a:lnTo>
                    <a:pt x="238" y="574"/>
                  </a:lnTo>
                  <a:lnTo>
                    <a:pt x="245" y="574"/>
                  </a:lnTo>
                  <a:lnTo>
                    <a:pt x="245" y="593"/>
                  </a:lnTo>
                  <a:lnTo>
                    <a:pt x="245" y="613"/>
                  </a:lnTo>
                  <a:lnTo>
                    <a:pt x="277" y="613"/>
                  </a:lnTo>
                  <a:lnTo>
                    <a:pt x="277" y="632"/>
                  </a:lnTo>
                  <a:lnTo>
                    <a:pt x="277" y="651"/>
                  </a:lnTo>
                  <a:lnTo>
                    <a:pt x="290" y="651"/>
                  </a:lnTo>
                  <a:lnTo>
                    <a:pt x="290" y="671"/>
                  </a:lnTo>
                  <a:lnTo>
                    <a:pt x="296" y="671"/>
                  </a:lnTo>
                  <a:lnTo>
                    <a:pt x="296" y="690"/>
                  </a:lnTo>
                  <a:lnTo>
                    <a:pt x="303" y="690"/>
                  </a:lnTo>
                  <a:lnTo>
                    <a:pt x="303" y="709"/>
                  </a:lnTo>
                  <a:lnTo>
                    <a:pt x="335" y="709"/>
                  </a:lnTo>
                  <a:lnTo>
                    <a:pt x="354" y="709"/>
                  </a:lnTo>
                  <a:lnTo>
                    <a:pt x="354" y="729"/>
                  </a:lnTo>
                  <a:lnTo>
                    <a:pt x="361" y="729"/>
                  </a:lnTo>
                  <a:lnTo>
                    <a:pt x="361" y="748"/>
                  </a:lnTo>
                  <a:lnTo>
                    <a:pt x="418" y="748"/>
                  </a:lnTo>
                  <a:lnTo>
                    <a:pt x="418" y="767"/>
                  </a:lnTo>
                  <a:lnTo>
                    <a:pt x="438" y="767"/>
                  </a:lnTo>
                  <a:lnTo>
                    <a:pt x="438" y="787"/>
                  </a:lnTo>
                  <a:lnTo>
                    <a:pt x="470" y="787"/>
                  </a:lnTo>
                  <a:lnTo>
                    <a:pt x="470" y="806"/>
                  </a:lnTo>
                  <a:lnTo>
                    <a:pt x="476" y="806"/>
                  </a:lnTo>
                  <a:lnTo>
                    <a:pt x="476" y="826"/>
                  </a:lnTo>
                  <a:lnTo>
                    <a:pt x="489" y="826"/>
                  </a:lnTo>
                  <a:lnTo>
                    <a:pt x="489" y="845"/>
                  </a:lnTo>
                  <a:lnTo>
                    <a:pt x="560" y="845"/>
                  </a:lnTo>
                  <a:lnTo>
                    <a:pt x="560" y="864"/>
                  </a:lnTo>
                  <a:lnTo>
                    <a:pt x="747" y="864"/>
                  </a:lnTo>
                  <a:lnTo>
                    <a:pt x="747" y="884"/>
                  </a:lnTo>
                  <a:lnTo>
                    <a:pt x="805" y="884"/>
                  </a:lnTo>
                  <a:lnTo>
                    <a:pt x="805" y="903"/>
                  </a:lnTo>
                  <a:lnTo>
                    <a:pt x="889" y="903"/>
                  </a:lnTo>
                  <a:lnTo>
                    <a:pt x="889" y="922"/>
                  </a:lnTo>
                  <a:lnTo>
                    <a:pt x="914" y="922"/>
                  </a:lnTo>
                  <a:lnTo>
                    <a:pt x="1011" y="922"/>
                  </a:lnTo>
                  <a:lnTo>
                    <a:pt x="1011" y="948"/>
                  </a:lnTo>
                  <a:lnTo>
                    <a:pt x="1030" y="948"/>
                  </a:lnTo>
                  <a:lnTo>
                    <a:pt x="1030" y="968"/>
                  </a:lnTo>
                  <a:lnTo>
                    <a:pt x="1114" y="968"/>
                  </a:lnTo>
                  <a:lnTo>
                    <a:pt x="1230" y="968"/>
                  </a:lnTo>
                  <a:lnTo>
                    <a:pt x="1230" y="993"/>
                  </a:lnTo>
                  <a:lnTo>
                    <a:pt x="1777" y="993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195" name="Line 127">
              <a:extLst>
                <a:ext uri="{FF2B5EF4-FFF2-40B4-BE49-F238E27FC236}">
                  <a16:creationId xmlns:a16="http://schemas.microsoft.com/office/drawing/2014/main" id="{B3952C7B-E450-4D3B-B012-E9E7EB7B49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74113" y="2060575"/>
              <a:ext cx="0" cy="18430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Line 128">
              <a:extLst>
                <a:ext uri="{FF2B5EF4-FFF2-40B4-BE49-F238E27FC236}">
                  <a16:creationId xmlns:a16="http://schemas.microsoft.com/office/drawing/2014/main" id="{8DCC8DC4-2877-48B3-B0DF-D1225CEBA6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74113" y="3903663"/>
              <a:ext cx="282098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Line 129">
              <a:extLst>
                <a:ext uri="{FF2B5EF4-FFF2-40B4-BE49-F238E27FC236}">
                  <a16:creationId xmlns:a16="http://schemas.microsoft.com/office/drawing/2014/main" id="{D834FEC1-3D51-4E55-8315-A14E600686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74113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130">
              <a:extLst>
                <a:ext uri="{FF2B5EF4-FFF2-40B4-BE49-F238E27FC236}">
                  <a16:creationId xmlns:a16="http://schemas.microsoft.com/office/drawing/2014/main" id="{ACE37509-DDCE-4E45-85B9-415C53D3C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2838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Line 131">
              <a:extLst>
                <a:ext uri="{FF2B5EF4-FFF2-40B4-BE49-F238E27FC236}">
                  <a16:creationId xmlns:a16="http://schemas.microsoft.com/office/drawing/2014/main" id="{A60176A4-8EBF-436D-BE09-FAF16DBA47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59863" y="3903663"/>
              <a:ext cx="0" cy="30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Line 132">
              <a:extLst>
                <a:ext uri="{FF2B5EF4-FFF2-40B4-BE49-F238E27FC236}">
                  <a16:creationId xmlns:a16="http://schemas.microsoft.com/office/drawing/2014/main" id="{40CA0C71-419C-45FF-BAF6-190C2AA887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36088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Rectangle 133">
              <a:extLst>
                <a:ext uri="{FF2B5EF4-FFF2-40B4-BE49-F238E27FC236}">
                  <a16:creationId xmlns:a16="http://schemas.microsoft.com/office/drawing/2014/main" id="{D26E0857-3C88-41B3-B08E-E0C872FAF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94813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Line 134">
              <a:extLst>
                <a:ext uri="{FF2B5EF4-FFF2-40B4-BE49-F238E27FC236}">
                  <a16:creationId xmlns:a16="http://schemas.microsoft.com/office/drawing/2014/main" id="{1CE1CF9E-F6E3-4081-947D-6FD078D477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21838" y="3903663"/>
              <a:ext cx="0" cy="30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Line 135">
              <a:extLst>
                <a:ext uri="{FF2B5EF4-FFF2-40B4-BE49-F238E27FC236}">
                  <a16:creationId xmlns:a16="http://schemas.microsoft.com/office/drawing/2014/main" id="{7F321DCF-A5E9-48CB-A967-EA26B56F07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98063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Rectangle 136">
              <a:extLst>
                <a:ext uri="{FF2B5EF4-FFF2-40B4-BE49-F238E27FC236}">
                  <a16:creationId xmlns:a16="http://schemas.microsoft.com/office/drawing/2014/main" id="{3764CADF-86D3-4326-AF7D-C1F0CD10E2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58375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Line 137">
              <a:extLst>
                <a:ext uri="{FF2B5EF4-FFF2-40B4-BE49-F238E27FC236}">
                  <a16:creationId xmlns:a16="http://schemas.microsoft.com/office/drawing/2014/main" id="{7485112B-B3DB-4DD4-BB54-5DB13FB3AA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85400" y="3903663"/>
              <a:ext cx="0" cy="30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Line 138">
              <a:extLst>
                <a:ext uri="{FF2B5EF4-FFF2-40B4-BE49-F238E27FC236}">
                  <a16:creationId xmlns:a16="http://schemas.microsoft.com/office/drawing/2014/main" id="{E86CD356-42B4-4311-8BD7-E7CB560146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71150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Rectangle 139">
              <a:extLst>
                <a:ext uri="{FF2B5EF4-FFF2-40B4-BE49-F238E27FC236}">
                  <a16:creationId xmlns:a16="http://schemas.microsoft.com/office/drawing/2014/main" id="{DF99317C-0249-44B9-81D0-5462B2AA3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29875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Line 140">
              <a:extLst>
                <a:ext uri="{FF2B5EF4-FFF2-40B4-BE49-F238E27FC236}">
                  <a16:creationId xmlns:a16="http://schemas.microsoft.com/office/drawing/2014/main" id="{C9D5B8D0-795E-434D-A0C5-FC5222E649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47375" y="3903663"/>
              <a:ext cx="0" cy="30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Line 141">
              <a:extLst>
                <a:ext uri="{FF2B5EF4-FFF2-40B4-BE49-F238E27FC236}">
                  <a16:creationId xmlns:a16="http://schemas.microsoft.com/office/drawing/2014/main" id="{9E3ECE7C-D3DC-4FD2-8158-0D3492E80E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033125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Rectangle 142">
              <a:extLst>
                <a:ext uri="{FF2B5EF4-FFF2-40B4-BE49-F238E27FC236}">
                  <a16:creationId xmlns:a16="http://schemas.microsoft.com/office/drawing/2014/main" id="{A51021E9-A20E-4B58-9527-B8F054AB66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91850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Line 143">
              <a:extLst>
                <a:ext uri="{FF2B5EF4-FFF2-40B4-BE49-F238E27FC236}">
                  <a16:creationId xmlns:a16="http://schemas.microsoft.com/office/drawing/2014/main" id="{965635F5-7D82-4187-93F5-BBD5561395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09350" y="3903663"/>
              <a:ext cx="0" cy="3016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Line 144">
              <a:extLst>
                <a:ext uri="{FF2B5EF4-FFF2-40B4-BE49-F238E27FC236}">
                  <a16:creationId xmlns:a16="http://schemas.microsoft.com/office/drawing/2014/main" id="{9749BBB4-0CB4-4C42-A2A7-51F3E6C839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595100" y="3903663"/>
              <a:ext cx="0" cy="619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Rectangle 145">
              <a:extLst>
                <a:ext uri="{FF2B5EF4-FFF2-40B4-BE49-F238E27FC236}">
                  <a16:creationId xmlns:a16="http://schemas.microsoft.com/office/drawing/2014/main" id="{9092C93F-D442-4659-B4F3-FE85EA289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55413" y="397510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4" name="グループ化 383">
            <a:extLst>
              <a:ext uri="{FF2B5EF4-FFF2-40B4-BE49-F238E27FC236}">
                <a16:creationId xmlns:a16="http://schemas.microsoft.com/office/drawing/2014/main" id="{F7B5AEB1-A853-499D-A035-614F953D705F}"/>
              </a:ext>
            </a:extLst>
          </p:cNvPr>
          <p:cNvGrpSpPr/>
          <p:nvPr/>
        </p:nvGrpSpPr>
        <p:grpSpPr>
          <a:xfrm>
            <a:off x="3004351" y="2196455"/>
            <a:ext cx="833184" cy="646331"/>
            <a:chOff x="3402386" y="1005282"/>
            <a:chExt cx="833184" cy="646331"/>
          </a:xfrm>
        </p:grpSpPr>
        <p:cxnSp>
          <p:nvCxnSpPr>
            <p:cNvPr id="385" name="直線コネクタ 384">
              <a:extLst>
                <a:ext uri="{FF2B5EF4-FFF2-40B4-BE49-F238E27FC236}">
                  <a16:creationId xmlns:a16="http://schemas.microsoft.com/office/drawing/2014/main" id="{FD324839-A46A-412E-BB87-468B8F9A6C23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134374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6" name="直線コネクタ 385">
              <a:extLst>
                <a:ext uri="{FF2B5EF4-FFF2-40B4-BE49-F238E27FC236}">
                  <a16:creationId xmlns:a16="http://schemas.microsoft.com/office/drawing/2014/main" id="{17AC3FA0-BCB5-421A-86AC-9AD2CF0E2F84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324874"/>
              <a:ext cx="211931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7" name="直線コネクタ 386">
              <a:extLst>
                <a:ext uri="{FF2B5EF4-FFF2-40B4-BE49-F238E27FC236}">
                  <a16:creationId xmlns:a16="http://schemas.microsoft.com/office/drawing/2014/main" id="{006E7E27-15DC-4084-8BCC-128CE47D9DEE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515374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8" name="テキスト ボックス 387">
              <a:extLst>
                <a:ext uri="{FF2B5EF4-FFF2-40B4-BE49-F238E27FC236}">
                  <a16:creationId xmlns:a16="http://schemas.microsoft.com/office/drawing/2014/main" id="{3ED67D4E-11E6-42BF-A14C-5B399B35F76E}"/>
                </a:ext>
              </a:extLst>
            </p:cNvPr>
            <p:cNvSpPr txBox="1"/>
            <p:nvPr/>
          </p:nvSpPr>
          <p:spPr>
            <a:xfrm>
              <a:off x="3579974" y="1005282"/>
              <a:ext cx="65559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9" name="グループ化 388">
            <a:extLst>
              <a:ext uri="{FF2B5EF4-FFF2-40B4-BE49-F238E27FC236}">
                <a16:creationId xmlns:a16="http://schemas.microsoft.com/office/drawing/2014/main" id="{AA7F7B48-3C81-4A31-852C-E7580334A73A}"/>
              </a:ext>
            </a:extLst>
          </p:cNvPr>
          <p:cNvGrpSpPr/>
          <p:nvPr/>
        </p:nvGrpSpPr>
        <p:grpSpPr>
          <a:xfrm>
            <a:off x="7106199" y="1173767"/>
            <a:ext cx="833184" cy="646331"/>
            <a:chOff x="3402386" y="1005282"/>
            <a:chExt cx="833184" cy="646331"/>
          </a:xfrm>
        </p:grpSpPr>
        <p:cxnSp>
          <p:nvCxnSpPr>
            <p:cNvPr id="390" name="直線コネクタ 389">
              <a:extLst>
                <a:ext uri="{FF2B5EF4-FFF2-40B4-BE49-F238E27FC236}">
                  <a16:creationId xmlns:a16="http://schemas.microsoft.com/office/drawing/2014/main" id="{34E0BB25-8F1E-4846-8368-B15BC73CF1AF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134374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直線コネクタ 390">
              <a:extLst>
                <a:ext uri="{FF2B5EF4-FFF2-40B4-BE49-F238E27FC236}">
                  <a16:creationId xmlns:a16="http://schemas.microsoft.com/office/drawing/2014/main" id="{79C8EC4C-1587-464D-BD3B-2965E8B3E58E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324874"/>
              <a:ext cx="211931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直線コネクタ 391">
              <a:extLst>
                <a:ext uri="{FF2B5EF4-FFF2-40B4-BE49-F238E27FC236}">
                  <a16:creationId xmlns:a16="http://schemas.microsoft.com/office/drawing/2014/main" id="{78F609BD-6CCC-472E-B5D3-7446761D619E}"/>
                </a:ext>
              </a:extLst>
            </p:cNvPr>
            <p:cNvCxnSpPr>
              <a:cxnSpLocks/>
            </p:cNvCxnSpPr>
            <p:nvPr/>
          </p:nvCxnSpPr>
          <p:spPr>
            <a:xfrm>
              <a:off x="3402386" y="1515374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3" name="テキスト ボックス 392">
              <a:extLst>
                <a:ext uri="{FF2B5EF4-FFF2-40B4-BE49-F238E27FC236}">
                  <a16:creationId xmlns:a16="http://schemas.microsoft.com/office/drawing/2014/main" id="{9A87C6D2-4C99-439C-AD22-C972D5D92E9F}"/>
                </a:ext>
              </a:extLst>
            </p:cNvPr>
            <p:cNvSpPr txBox="1"/>
            <p:nvPr/>
          </p:nvSpPr>
          <p:spPr>
            <a:xfrm>
              <a:off x="3579974" y="1005282"/>
              <a:ext cx="65559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dle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94" name="グループ化 393">
            <a:extLst>
              <a:ext uri="{FF2B5EF4-FFF2-40B4-BE49-F238E27FC236}">
                <a16:creationId xmlns:a16="http://schemas.microsoft.com/office/drawing/2014/main" id="{6AED1A8A-4E48-4DDE-85AA-D4DBC1BD38B7}"/>
              </a:ext>
            </a:extLst>
          </p:cNvPr>
          <p:cNvGrpSpPr/>
          <p:nvPr/>
        </p:nvGrpSpPr>
        <p:grpSpPr>
          <a:xfrm>
            <a:off x="10494134" y="1200328"/>
            <a:ext cx="1431523" cy="461665"/>
            <a:chOff x="5346033" y="912919"/>
            <a:chExt cx="1429676" cy="461665"/>
          </a:xfrm>
        </p:grpSpPr>
        <p:cxnSp>
          <p:nvCxnSpPr>
            <p:cNvPr id="395" name="直線コネクタ 394">
              <a:extLst>
                <a:ext uri="{FF2B5EF4-FFF2-40B4-BE49-F238E27FC236}">
                  <a16:creationId xmlns:a16="http://schemas.microsoft.com/office/drawing/2014/main" id="{9C7C8B20-1B53-4F5A-BF5E-4E47D01E82AB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042011"/>
              <a:ext cx="211931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6" name="直線コネクタ 395">
              <a:extLst>
                <a:ext uri="{FF2B5EF4-FFF2-40B4-BE49-F238E27FC236}">
                  <a16:creationId xmlns:a16="http://schemas.microsoft.com/office/drawing/2014/main" id="{3DC6AD6B-5086-4951-9B71-46A4DF5A8631}"/>
                </a:ext>
              </a:extLst>
            </p:cNvPr>
            <p:cNvCxnSpPr>
              <a:cxnSpLocks/>
            </p:cNvCxnSpPr>
            <p:nvPr/>
          </p:nvCxnSpPr>
          <p:spPr>
            <a:xfrm>
              <a:off x="5346033" y="1232511"/>
              <a:ext cx="211931" cy="0"/>
            </a:xfrm>
            <a:prstGeom prst="line">
              <a:avLst/>
            </a:prstGeom>
            <a:ln w="28575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7" name="テキスト ボックス 396">
              <a:extLst>
                <a:ext uri="{FF2B5EF4-FFF2-40B4-BE49-F238E27FC236}">
                  <a16:creationId xmlns:a16="http://schemas.microsoft.com/office/drawing/2014/main" id="{5CF595B9-723A-44EB-978D-9B879DF96DB8}"/>
                </a:ext>
              </a:extLst>
            </p:cNvPr>
            <p:cNvSpPr txBox="1"/>
            <p:nvPr/>
          </p:nvSpPr>
          <p:spPr>
            <a:xfrm>
              <a:off x="5523621" y="912919"/>
              <a:ext cx="12520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and Middle</a:t>
              </a:r>
            </a:p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8" name="Text Box 94">
            <a:extLst>
              <a:ext uri="{FF2B5EF4-FFF2-40B4-BE49-F238E27FC236}">
                <a16:creationId xmlns:a16="http://schemas.microsoft.com/office/drawing/2014/main" id="{D21D2FD0-88E2-4E97-A2BD-C7F047001CDC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4301363" y="1221611"/>
            <a:ext cx="400110" cy="1892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algn="ctr">
              <a:tabLst>
                <a:tab pos="265113" algn="l"/>
              </a:tabLst>
              <a:defRPr/>
            </a:pPr>
            <a:r>
              <a:rPr lang="en-US" altLang="ja-JP" sz="14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Survival probability</a:t>
            </a:r>
            <a:endParaRPr lang="ja-JP" altLang="en-US" sz="1400" kern="0" dirty="0">
              <a:solidFill>
                <a:sysClr val="windowText" lastClr="000000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399" name="Text Box 94">
            <a:extLst>
              <a:ext uri="{FF2B5EF4-FFF2-40B4-BE49-F238E27FC236}">
                <a16:creationId xmlns:a16="http://schemas.microsoft.com/office/drawing/2014/main" id="{B4EE6282-F924-4E24-A0E5-B9E2578BFBE6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330769" y="1221611"/>
            <a:ext cx="400110" cy="1892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algn="ctr">
              <a:tabLst>
                <a:tab pos="265113" algn="l"/>
              </a:tabLst>
              <a:defRPr/>
            </a:pPr>
            <a:r>
              <a:rPr lang="en-US" altLang="ja-JP" sz="14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Survival probability</a:t>
            </a:r>
            <a:endParaRPr lang="ja-JP" altLang="en-US" sz="1400" kern="0" dirty="0">
              <a:solidFill>
                <a:sysClr val="windowText" lastClr="000000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400" name="Text Box 94">
            <a:extLst>
              <a:ext uri="{FF2B5EF4-FFF2-40B4-BE49-F238E27FC236}">
                <a16:creationId xmlns:a16="http://schemas.microsoft.com/office/drawing/2014/main" id="{F94994BB-393C-4685-A7F6-95D735D072CE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8299005" y="1221610"/>
            <a:ext cx="400110" cy="1892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algn="ctr">
              <a:tabLst>
                <a:tab pos="265113" algn="l"/>
              </a:tabLst>
              <a:defRPr/>
            </a:pPr>
            <a:r>
              <a:rPr lang="en-US" altLang="ja-JP" sz="14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Survival probability</a:t>
            </a:r>
            <a:endParaRPr lang="ja-JP" altLang="en-US" sz="1400" kern="0" dirty="0">
              <a:solidFill>
                <a:sysClr val="windowText" lastClr="000000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401" name="テキスト ボックス 400">
            <a:extLst>
              <a:ext uri="{FF2B5EF4-FFF2-40B4-BE49-F238E27FC236}">
                <a16:creationId xmlns:a16="http://schemas.microsoft.com/office/drawing/2014/main" id="{A816791E-3BDA-4FEA-AC3F-8A5394A41128}"/>
              </a:ext>
            </a:extLst>
          </p:cNvPr>
          <p:cNvSpPr txBox="1"/>
          <p:nvPr/>
        </p:nvSpPr>
        <p:spPr>
          <a:xfrm>
            <a:off x="1132073" y="3333037"/>
            <a:ext cx="2595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(year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テキスト ボックス 401">
            <a:extLst>
              <a:ext uri="{FF2B5EF4-FFF2-40B4-BE49-F238E27FC236}">
                <a16:creationId xmlns:a16="http://schemas.microsoft.com/office/drawing/2014/main" id="{6F675F92-D5DC-4495-834C-EA907559928E}"/>
              </a:ext>
            </a:extLst>
          </p:cNvPr>
          <p:cNvSpPr txBox="1"/>
          <p:nvPr/>
        </p:nvSpPr>
        <p:spPr>
          <a:xfrm>
            <a:off x="9062800" y="3332204"/>
            <a:ext cx="2595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Relapse-free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(year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A1D20EA1-39A0-4CC3-B931-9139DBB7AEA3}"/>
              </a:ext>
            </a:extLst>
          </p:cNvPr>
          <p:cNvSpPr txBox="1"/>
          <p:nvPr/>
        </p:nvSpPr>
        <p:spPr>
          <a:xfrm>
            <a:off x="5118562" y="1194029"/>
            <a:ext cx="1835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test for trend</a:t>
            </a:r>
          </a:p>
          <a:p>
            <a:pPr algn="ctr"/>
            <a:r>
              <a:rPr kumimoji="1" lang="en-US" altLang="ja-JP" sz="14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024</a:t>
            </a:r>
            <a:endParaRPr kumimoji="1" lang="en-US" altLang="ja-JP" sz="14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4" name="テキスト ボックス 403">
            <a:extLst>
              <a:ext uri="{FF2B5EF4-FFF2-40B4-BE49-F238E27FC236}">
                <a16:creationId xmlns:a16="http://schemas.microsoft.com/office/drawing/2014/main" id="{1FE7FDFE-A2B3-4851-81F3-1AE390BFD217}"/>
              </a:ext>
            </a:extLst>
          </p:cNvPr>
          <p:cNvSpPr txBox="1"/>
          <p:nvPr/>
        </p:nvSpPr>
        <p:spPr>
          <a:xfrm>
            <a:off x="8959939" y="1197368"/>
            <a:ext cx="16727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</a:t>
            </a:r>
          </a:p>
          <a:p>
            <a:pPr algn="ctr"/>
            <a:r>
              <a:rPr kumimoji="1" lang="en-US" altLang="ja-JP" sz="14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006</a:t>
            </a:r>
            <a:endParaRPr kumimoji="1" lang="en-US" altLang="ja-JP" sz="14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5" name="テキスト ボックス 404">
            <a:extLst>
              <a:ext uri="{FF2B5EF4-FFF2-40B4-BE49-F238E27FC236}">
                <a16:creationId xmlns:a16="http://schemas.microsoft.com/office/drawing/2014/main" id="{3AAB391D-3A5C-41CC-B37F-022004AE72A6}"/>
              </a:ext>
            </a:extLst>
          </p:cNvPr>
          <p:cNvSpPr txBox="1"/>
          <p:nvPr/>
        </p:nvSpPr>
        <p:spPr>
          <a:xfrm>
            <a:off x="4981667" y="3332203"/>
            <a:ext cx="2822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-free survival (years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テキスト ボックス 405">
            <a:extLst>
              <a:ext uri="{FF2B5EF4-FFF2-40B4-BE49-F238E27FC236}">
                <a16:creationId xmlns:a16="http://schemas.microsoft.com/office/drawing/2014/main" id="{E52B833D-62D0-4B93-AAA4-D5F494BE2B53}"/>
              </a:ext>
            </a:extLst>
          </p:cNvPr>
          <p:cNvSpPr txBox="1"/>
          <p:nvPr/>
        </p:nvSpPr>
        <p:spPr>
          <a:xfrm>
            <a:off x="969977" y="2241398"/>
            <a:ext cx="1963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Log-rank test for trend</a:t>
            </a:r>
          </a:p>
          <a:p>
            <a:pPr algn="ctr"/>
            <a:r>
              <a:rPr kumimoji="1" lang="en-US" altLang="ja-JP" sz="1400" i="1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140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= 0</a:t>
            </a:r>
            <a:r>
              <a:rPr lang="en-US" altLang="ja-JP" sz="140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rPr>
              <a:t>.37</a:t>
            </a:r>
            <a:endParaRPr kumimoji="1" lang="en-US" altLang="ja-JP" sz="1400" dirty="0">
              <a:latin typeface="Times New Roman" panose="02020603050405020304" pitchFamily="18" charset="0"/>
              <a:ea typeface="HGP創英角ｺﾞｼｯｸUB" panose="020B09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407" name="表 24">
            <a:extLst>
              <a:ext uri="{FF2B5EF4-FFF2-40B4-BE49-F238E27FC236}">
                <a16:creationId xmlns:a16="http://schemas.microsoft.com/office/drawing/2014/main" id="{1733BC1B-282F-4C92-AED2-91FA17F4C1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335596"/>
              </p:ext>
            </p:extLst>
          </p:nvPr>
        </p:nvGraphicFramePr>
        <p:xfrm>
          <a:off x="459599" y="4163199"/>
          <a:ext cx="3655801" cy="1386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95801">
                  <a:extLst>
                    <a:ext uri="{9D8B030D-6E8A-4147-A177-3AD203B41FA5}">
                      <a16:colId xmlns:a16="http://schemas.microsoft.com/office/drawing/2014/main" val="123428493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115888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4222958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907527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037064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2109145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209548077"/>
                    </a:ext>
                  </a:extLst>
                </a:gridCol>
              </a:tblGrid>
              <a:tr h="1397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8201164"/>
                  </a:ext>
                </a:extLst>
              </a:tr>
              <a:tr h="1397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0185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CD8</a:t>
                      </a:r>
                      <a:r>
                        <a:rPr kumimoji="1" lang="en-US" altLang="ja-JP" sz="1200" i="0" baseline="300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00020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ddle CD8</a:t>
                      </a:r>
                      <a:r>
                        <a:rPr kumimoji="1" lang="en-US" altLang="ja-JP" sz="1200" i="0" baseline="3000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00B05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610399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CD8</a:t>
                      </a:r>
                      <a:r>
                        <a:rPr kumimoji="1" lang="en-US" altLang="ja-JP" sz="1200" i="0" baseline="30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00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8601766"/>
                  </a:ext>
                </a:extLst>
              </a:tr>
            </a:tbl>
          </a:graphicData>
        </a:graphic>
      </p:graphicFrame>
      <p:sp>
        <p:nvSpPr>
          <p:cNvPr id="408" name="テキスト ボックス 407">
            <a:extLst>
              <a:ext uri="{FF2B5EF4-FFF2-40B4-BE49-F238E27FC236}">
                <a16:creationId xmlns:a16="http://schemas.microsoft.com/office/drawing/2014/main" id="{72BB9EEC-436F-4C52-86DE-3F4A6ABEC38D}"/>
              </a:ext>
            </a:extLst>
          </p:cNvPr>
          <p:cNvSpPr txBox="1"/>
          <p:nvPr/>
        </p:nvSpPr>
        <p:spPr>
          <a:xfrm>
            <a:off x="459599" y="3886200"/>
            <a:ext cx="1277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09" name="表 24">
            <a:extLst>
              <a:ext uri="{FF2B5EF4-FFF2-40B4-BE49-F238E27FC236}">
                <a16:creationId xmlns:a16="http://schemas.microsoft.com/office/drawing/2014/main" id="{9A5E2E2A-068E-4AA7-B1A8-7E6118410E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407734"/>
              </p:ext>
            </p:extLst>
          </p:nvPr>
        </p:nvGraphicFramePr>
        <p:xfrm>
          <a:off x="8084150" y="4160561"/>
          <a:ext cx="4031650" cy="1285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39650">
                  <a:extLst>
                    <a:ext uri="{9D8B030D-6E8A-4147-A177-3AD203B41FA5}">
                      <a16:colId xmlns:a16="http://schemas.microsoft.com/office/drawing/2014/main" val="123428493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24115888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342229584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09075278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103706498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3821091457"/>
                    </a:ext>
                  </a:extLst>
                </a:gridCol>
                <a:gridCol w="432000">
                  <a:extLst>
                    <a:ext uri="{9D8B030D-6E8A-4147-A177-3AD203B41FA5}">
                      <a16:colId xmlns:a16="http://schemas.microsoft.com/office/drawing/2014/main" val="4209548077"/>
                    </a:ext>
                  </a:extLst>
                </a:gridCol>
              </a:tblGrid>
              <a:tr h="1397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8201164"/>
                  </a:ext>
                </a:extLst>
              </a:tr>
              <a:tr h="1397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489386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and middle CD8</a:t>
                      </a:r>
                      <a:r>
                        <a:rPr kumimoji="1" lang="en-US" altLang="ja-JP" sz="1200" i="0" baseline="300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00020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CD8</a:t>
                      </a:r>
                      <a:r>
                        <a:rPr kumimoji="1" lang="en-US" altLang="ja-JP" sz="1200" i="0" baseline="30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00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610399"/>
                  </a:ext>
                </a:extLst>
              </a:tr>
            </a:tbl>
          </a:graphicData>
        </a:graphic>
      </p:graphicFrame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7E6C8B99-73BE-41AF-8936-D2F88EB6F0D9}"/>
              </a:ext>
            </a:extLst>
          </p:cNvPr>
          <p:cNvSpPr txBox="1"/>
          <p:nvPr/>
        </p:nvSpPr>
        <p:spPr>
          <a:xfrm>
            <a:off x="8079907" y="3886200"/>
            <a:ext cx="1277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11" name="表 24">
            <a:extLst>
              <a:ext uri="{FF2B5EF4-FFF2-40B4-BE49-F238E27FC236}">
                <a16:creationId xmlns:a16="http://schemas.microsoft.com/office/drawing/2014/main" id="{9A1F9ECC-6DD7-40DB-9978-54E7D5E3D0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5946997"/>
              </p:ext>
            </p:extLst>
          </p:nvPr>
        </p:nvGraphicFramePr>
        <p:xfrm>
          <a:off x="4271874" y="4160561"/>
          <a:ext cx="3655801" cy="1386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95801">
                  <a:extLst>
                    <a:ext uri="{9D8B030D-6E8A-4147-A177-3AD203B41FA5}">
                      <a16:colId xmlns:a16="http://schemas.microsoft.com/office/drawing/2014/main" val="123428493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115888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4222958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907527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037064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2109145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209548077"/>
                    </a:ext>
                  </a:extLst>
                </a:gridCol>
              </a:tblGrid>
              <a:tr h="1397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8201164"/>
                  </a:ext>
                </a:extLst>
              </a:tr>
              <a:tr h="1397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0548687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CD8</a:t>
                      </a:r>
                      <a:r>
                        <a:rPr kumimoji="1" lang="en-US" altLang="ja-JP" sz="1200" i="0" baseline="300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000203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ddle CD8</a:t>
                      </a:r>
                      <a:r>
                        <a:rPr kumimoji="1" lang="en-US" altLang="ja-JP" sz="1200" i="0" baseline="3000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00B05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00B05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7610399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CD8</a:t>
                      </a:r>
                      <a:r>
                        <a:rPr kumimoji="1" lang="en-US" altLang="ja-JP" sz="1200" i="0" baseline="30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kumimoji="1" lang="en-US" altLang="ja-JP" sz="1200" i="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 cells</a:t>
                      </a:r>
                      <a:endParaRPr kumimoji="1" lang="ja-JP" altLang="en-US" sz="1200" i="0" dirty="0">
                        <a:solidFill>
                          <a:srgbClr val="0000FF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8601766"/>
                  </a:ext>
                </a:extLst>
              </a:tr>
            </a:tbl>
          </a:graphicData>
        </a:graphic>
      </p:graphicFrame>
      <p:sp>
        <p:nvSpPr>
          <p:cNvPr id="412" name="テキスト ボックス 411">
            <a:extLst>
              <a:ext uri="{FF2B5EF4-FFF2-40B4-BE49-F238E27FC236}">
                <a16:creationId xmlns:a16="http://schemas.microsoft.com/office/drawing/2014/main" id="{E9568BA2-EB05-4E9A-8265-B65C421AD29B}"/>
              </a:ext>
            </a:extLst>
          </p:cNvPr>
          <p:cNvSpPr txBox="1"/>
          <p:nvPr/>
        </p:nvSpPr>
        <p:spPr>
          <a:xfrm>
            <a:off x="4277145" y="3886200"/>
            <a:ext cx="1277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8E7B4A-620B-4C26-AEE7-50908E46949F}"/>
              </a:ext>
            </a:extLst>
          </p:cNvPr>
          <p:cNvSpPr txBox="1"/>
          <p:nvPr/>
        </p:nvSpPr>
        <p:spPr>
          <a:xfrm>
            <a:off x="268468" y="5627806"/>
            <a:ext cx="113993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2. CD8</a:t>
            </a:r>
            <a:r>
              <a:rPr lang="en-GB" altLang="ja-JP" sz="1400" b="1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 cells and patients’ prognosis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Overall survival after curative resection of colorectal cancer liver metastases, grouping CD8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-cell numbers into </a:t>
            </a:r>
            <a:r>
              <a:rPr lang="en-GB" altLang="ja-JP" sz="14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iles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(B) Relapse-free survival after curative resection of colorectal cancer liver metastases, grouping CD8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-cell numbers into </a:t>
            </a:r>
            <a:r>
              <a:rPr lang="en-GB" altLang="ja-JP" sz="14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iles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GB" altLang="ja-JP" sz="14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 Relapse-free 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rvival after curative resection of colorectal cancer liver metastases between the group with high and middle infiltration of CD8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 cells and the group with low infiltration of CD8</a:t>
            </a:r>
            <a:r>
              <a:rPr lang="en-GB" altLang="ja-JP" sz="14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 cells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591052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71</TotalTime>
  <Words>311</Words>
  <Application>Microsoft Office PowerPoint</Application>
  <PresentationFormat>ワイド画面</PresentationFormat>
  <Paragraphs>1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Company>Partners HealthCare System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tners Information Systems</dc:creator>
  <cp:lastModifiedBy>坂本 悠樹</cp:lastModifiedBy>
  <cp:revision>1090</cp:revision>
  <cp:lastPrinted>2019-01-07T05:05:10Z</cp:lastPrinted>
  <dcterms:created xsi:type="dcterms:W3CDTF">2015-04-16T18:54:03Z</dcterms:created>
  <dcterms:modified xsi:type="dcterms:W3CDTF">2021-08-17T12:06:32Z</dcterms:modified>
</cp:coreProperties>
</file>